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5"/>
  </p:notesMasterIdLst>
  <p:sldIdLst>
    <p:sldId id="283" r:id="rId5"/>
    <p:sldId id="272" r:id="rId6"/>
    <p:sldId id="275" r:id="rId7"/>
    <p:sldId id="273" r:id="rId8"/>
    <p:sldId id="274" r:id="rId9"/>
    <p:sldId id="282" r:id="rId10"/>
    <p:sldId id="257" r:id="rId11"/>
    <p:sldId id="284" r:id="rId12"/>
    <p:sldId id="276" r:id="rId13"/>
    <p:sldId id="285" r:id="rId1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0E4F4D6-5304-4376-A353-FDA99DE40B88}" v="15" dt="2025-07-02T23:45:41.4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232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hki\Documents\working_space\&#30740;&#31350;&#23460;\R7&#24180;&#24230;\ChEC88\&#32233;&#21644;\2025.3.17%20ChEC88%20residue%20T1%20estimat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hki\Documents\working_space\&#30740;&#31350;&#23460;\R7&#24180;&#24230;\ChEC88\&#32233;&#21644;\20250421_T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hki\Documents\working_space\&#30740;&#31350;&#23460;\R7&#24180;&#24230;\ChEC88\&#32233;&#21644;\2025.3.2%20HQSC-NOEonNOEOoff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autoTitleDeleted val="1"/>
    <c:plotArea>
      <c:layout>
        <c:manualLayout>
          <c:layoutTarget val="inner"/>
          <c:xMode val="edge"/>
          <c:yMode val="edge"/>
          <c:x val="4.6483754971375579E-2"/>
          <c:y val="0.10866179227596551"/>
          <c:w val="0.93227921965008653"/>
          <c:h val="0.805060742407199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:$E</c:f>
                <c:numCache>
                  <c:formatCode>General</c:formatCode>
                  <c:ptCount val="1048576"/>
                  <c:pt idx="1">
                    <c:v>3.7860000000000005E-2</c:v>
                  </c:pt>
                  <c:pt idx="2">
                    <c:v>0</c:v>
                  </c:pt>
                  <c:pt idx="3">
                    <c:v>3.7860000000000005E-2</c:v>
                  </c:pt>
                  <c:pt idx="4">
                    <c:v>4.5054999999999956E-2</c:v>
                  </c:pt>
                  <c:pt idx="5">
                    <c:v>5.2989999999999982E-2</c:v>
                  </c:pt>
                  <c:pt idx="6">
                    <c:v>5.593999999999999E-2</c:v>
                  </c:pt>
                  <c:pt idx="7">
                    <c:v>3.4684999999999966E-2</c:v>
                  </c:pt>
                  <c:pt idx="8">
                    <c:v>3.8754999999999984E-2</c:v>
                  </c:pt>
                  <c:pt idx="9">
                    <c:v>0</c:v>
                  </c:pt>
                  <c:pt idx="10">
                    <c:v>5.4180000000000006E-2</c:v>
                  </c:pt>
                  <c:pt idx="11">
                    <c:v>0.10080999999999996</c:v>
                  </c:pt>
                  <c:pt idx="12">
                    <c:v>4.310500000000006E-2</c:v>
                  </c:pt>
                  <c:pt idx="13">
                    <c:v>4.5289999999999941E-2</c:v>
                  </c:pt>
                  <c:pt idx="14">
                    <c:v>5.5325000000000069E-2</c:v>
                  </c:pt>
                  <c:pt idx="15">
                    <c:v>0</c:v>
                  </c:pt>
                  <c:pt idx="16">
                    <c:v>5.2215000000000011E-2</c:v>
                  </c:pt>
                  <c:pt idx="17">
                    <c:v>0</c:v>
                  </c:pt>
                  <c:pt idx="18">
                    <c:v>4.7760000000000025E-2</c:v>
                  </c:pt>
                  <c:pt idx="19">
                    <c:v>5.6984999999999952E-2</c:v>
                  </c:pt>
                  <c:pt idx="20">
                    <c:v>6.8589999999999929E-2</c:v>
                  </c:pt>
                  <c:pt idx="21">
                    <c:v>4.6370000000000022E-2</c:v>
                  </c:pt>
                  <c:pt idx="22">
                    <c:v>3.6780000000000035E-2</c:v>
                  </c:pt>
                  <c:pt idx="23">
                    <c:v>1.809000000000005E-2</c:v>
                  </c:pt>
                  <c:pt idx="24">
                    <c:v>5.535000000000001E-2</c:v>
                  </c:pt>
                  <c:pt idx="25">
                    <c:v>4.6155000000000057E-2</c:v>
                  </c:pt>
                  <c:pt idx="26">
                    <c:v>4.5444999999999958E-2</c:v>
                  </c:pt>
                  <c:pt idx="27">
                    <c:v>4.2255000000000043E-2</c:v>
                  </c:pt>
                  <c:pt idx="28">
                    <c:v>4.6440000000000037E-2</c:v>
                  </c:pt>
                  <c:pt idx="29">
                    <c:v>7.8780000000000072E-2</c:v>
                  </c:pt>
                  <c:pt idx="30">
                    <c:v>9.7484999999999933E-2</c:v>
                  </c:pt>
                  <c:pt idx="31">
                    <c:v>5.7414999999999994E-2</c:v>
                  </c:pt>
                  <c:pt idx="32">
                    <c:v>2.4124999999999952E-2</c:v>
                  </c:pt>
                  <c:pt idx="33">
                    <c:v>1.8300000000000094E-2</c:v>
                  </c:pt>
                  <c:pt idx="34">
                    <c:v>3.2179999999999986E-2</c:v>
                  </c:pt>
                  <c:pt idx="35">
                    <c:v>0</c:v>
                  </c:pt>
                  <c:pt idx="36">
                    <c:v>5.8100000000000041E-2</c:v>
                  </c:pt>
                  <c:pt idx="37">
                    <c:v>1.7185000000000006E-2</c:v>
                  </c:pt>
                  <c:pt idx="38">
                    <c:v>3.6719999999999975E-2</c:v>
                  </c:pt>
                  <c:pt idx="39">
                    <c:v>7.6045000000000029E-2</c:v>
                  </c:pt>
                  <c:pt idx="40">
                    <c:v>5.2004999999999968E-2</c:v>
                  </c:pt>
                  <c:pt idx="41">
                    <c:v>7.4160000000000004E-2</c:v>
                  </c:pt>
                  <c:pt idx="42">
                    <c:v>7.4849999999999972E-2</c:v>
                  </c:pt>
                  <c:pt idx="43">
                    <c:v>7.7625000000000055E-2</c:v>
                  </c:pt>
                  <c:pt idx="44">
                    <c:v>0.17345500000000003</c:v>
                  </c:pt>
                  <c:pt idx="45">
                    <c:v>0.10444999999999993</c:v>
                  </c:pt>
                  <c:pt idx="46">
                    <c:v>5.8194999999999997E-2</c:v>
                  </c:pt>
                  <c:pt idx="47">
                    <c:v>5.3494999999999959E-2</c:v>
                  </c:pt>
                  <c:pt idx="48">
                    <c:v>2.937500000000004E-2</c:v>
                  </c:pt>
                  <c:pt idx="49">
                    <c:v>4.2000000000000037E-2</c:v>
                  </c:pt>
                  <c:pt idx="50">
                    <c:v>1.3624999999999998E-2</c:v>
                  </c:pt>
                  <c:pt idx="51">
                    <c:v>3.318500000000002E-2</c:v>
                  </c:pt>
                  <c:pt idx="52">
                    <c:v>1.9124999999999948E-2</c:v>
                  </c:pt>
                  <c:pt idx="53">
                    <c:v>4.1154999999999942E-2</c:v>
                  </c:pt>
                  <c:pt idx="54">
                    <c:v>4.793499999999995E-2</c:v>
                  </c:pt>
                  <c:pt idx="55">
                    <c:v>2.9629999999999934E-2</c:v>
                  </c:pt>
                  <c:pt idx="56">
                    <c:v>5.2494999999999958E-2</c:v>
                  </c:pt>
                  <c:pt idx="57">
                    <c:v>3.4270000000000023E-2</c:v>
                  </c:pt>
                  <c:pt idx="58">
                    <c:v>4.9644999999999939E-2</c:v>
                  </c:pt>
                  <c:pt idx="59">
                    <c:v>6.2334999999999918E-2</c:v>
                  </c:pt>
                  <c:pt idx="60">
                    <c:v>5.7124999999999981E-2</c:v>
                  </c:pt>
                  <c:pt idx="61">
                    <c:v>3.2805000000000084E-2</c:v>
                  </c:pt>
                  <c:pt idx="62">
                    <c:v>3.5525000000000029E-2</c:v>
                  </c:pt>
                  <c:pt idx="63">
                    <c:v>4.8895000000000022E-2</c:v>
                  </c:pt>
                  <c:pt idx="64">
                    <c:v>4.964500000000005E-2</c:v>
                  </c:pt>
                  <c:pt idx="65">
                    <c:v>0</c:v>
                  </c:pt>
                  <c:pt idx="66">
                    <c:v>8.3494999999999986E-2</c:v>
                  </c:pt>
                  <c:pt idx="67">
                    <c:v>4.4874999999999998E-2</c:v>
                  </c:pt>
                  <c:pt idx="68">
                    <c:v>3.6354999999999915E-2</c:v>
                  </c:pt>
                  <c:pt idx="69">
                    <c:v>4.4314999999999993E-2</c:v>
                  </c:pt>
                  <c:pt idx="70">
                    <c:v>2.7895000000000003E-2</c:v>
                  </c:pt>
                  <c:pt idx="71">
                    <c:v>2.9584999999999972E-2</c:v>
                  </c:pt>
                  <c:pt idx="72">
                    <c:v>3.2159999999999966E-2</c:v>
                  </c:pt>
                  <c:pt idx="73">
                    <c:v>0</c:v>
                  </c:pt>
                  <c:pt idx="74">
                    <c:v>5.7064999999999921E-2</c:v>
                  </c:pt>
                  <c:pt idx="75">
                    <c:v>4.8699999999999966E-2</c:v>
                  </c:pt>
                  <c:pt idx="76">
                    <c:v>6.1315000000000008E-2</c:v>
                  </c:pt>
                  <c:pt idx="77">
                    <c:v>4.9399999999999999E-2</c:v>
                  </c:pt>
                </c:numCache>
              </c:numRef>
            </c:plus>
            <c:minus>
              <c:numRef>
                <c:f>Sheet1!$E:$E</c:f>
                <c:numCache>
                  <c:formatCode>General</c:formatCode>
                  <c:ptCount val="1048576"/>
                  <c:pt idx="1">
                    <c:v>3.7860000000000005E-2</c:v>
                  </c:pt>
                  <c:pt idx="2">
                    <c:v>0</c:v>
                  </c:pt>
                  <c:pt idx="3">
                    <c:v>3.7860000000000005E-2</c:v>
                  </c:pt>
                  <c:pt idx="4">
                    <c:v>4.5054999999999956E-2</c:v>
                  </c:pt>
                  <c:pt idx="5">
                    <c:v>5.2989999999999982E-2</c:v>
                  </c:pt>
                  <c:pt idx="6">
                    <c:v>5.593999999999999E-2</c:v>
                  </c:pt>
                  <c:pt idx="7">
                    <c:v>3.4684999999999966E-2</c:v>
                  </c:pt>
                  <c:pt idx="8">
                    <c:v>3.8754999999999984E-2</c:v>
                  </c:pt>
                  <c:pt idx="9">
                    <c:v>0</c:v>
                  </c:pt>
                  <c:pt idx="10">
                    <c:v>5.4180000000000006E-2</c:v>
                  </c:pt>
                  <c:pt idx="11">
                    <c:v>0.10080999999999996</c:v>
                  </c:pt>
                  <c:pt idx="12">
                    <c:v>4.310500000000006E-2</c:v>
                  </c:pt>
                  <c:pt idx="13">
                    <c:v>4.5289999999999941E-2</c:v>
                  </c:pt>
                  <c:pt idx="14">
                    <c:v>5.5325000000000069E-2</c:v>
                  </c:pt>
                  <c:pt idx="15">
                    <c:v>0</c:v>
                  </c:pt>
                  <c:pt idx="16">
                    <c:v>5.2215000000000011E-2</c:v>
                  </c:pt>
                  <c:pt idx="17">
                    <c:v>0</c:v>
                  </c:pt>
                  <c:pt idx="18">
                    <c:v>4.7760000000000025E-2</c:v>
                  </c:pt>
                  <c:pt idx="19">
                    <c:v>5.6984999999999952E-2</c:v>
                  </c:pt>
                  <c:pt idx="20">
                    <c:v>6.8589999999999929E-2</c:v>
                  </c:pt>
                  <c:pt idx="21">
                    <c:v>4.6370000000000022E-2</c:v>
                  </c:pt>
                  <c:pt idx="22">
                    <c:v>3.6780000000000035E-2</c:v>
                  </c:pt>
                  <c:pt idx="23">
                    <c:v>1.809000000000005E-2</c:v>
                  </c:pt>
                  <c:pt idx="24">
                    <c:v>5.535000000000001E-2</c:v>
                  </c:pt>
                  <c:pt idx="25">
                    <c:v>4.6155000000000057E-2</c:v>
                  </c:pt>
                  <c:pt idx="26">
                    <c:v>4.5444999999999958E-2</c:v>
                  </c:pt>
                  <c:pt idx="27">
                    <c:v>4.2255000000000043E-2</c:v>
                  </c:pt>
                  <c:pt idx="28">
                    <c:v>4.6440000000000037E-2</c:v>
                  </c:pt>
                  <c:pt idx="29">
                    <c:v>7.8780000000000072E-2</c:v>
                  </c:pt>
                  <c:pt idx="30">
                    <c:v>9.7484999999999933E-2</c:v>
                  </c:pt>
                  <c:pt idx="31">
                    <c:v>5.7414999999999994E-2</c:v>
                  </c:pt>
                  <c:pt idx="32">
                    <c:v>2.4124999999999952E-2</c:v>
                  </c:pt>
                  <c:pt idx="33">
                    <c:v>1.8300000000000094E-2</c:v>
                  </c:pt>
                  <c:pt idx="34">
                    <c:v>3.2179999999999986E-2</c:v>
                  </c:pt>
                  <c:pt idx="35">
                    <c:v>0</c:v>
                  </c:pt>
                  <c:pt idx="36">
                    <c:v>5.8100000000000041E-2</c:v>
                  </c:pt>
                  <c:pt idx="37">
                    <c:v>1.7185000000000006E-2</c:v>
                  </c:pt>
                  <c:pt idx="38">
                    <c:v>3.6719999999999975E-2</c:v>
                  </c:pt>
                  <c:pt idx="39">
                    <c:v>7.6045000000000029E-2</c:v>
                  </c:pt>
                  <c:pt idx="40">
                    <c:v>5.2004999999999968E-2</c:v>
                  </c:pt>
                  <c:pt idx="41">
                    <c:v>7.4160000000000004E-2</c:v>
                  </c:pt>
                  <c:pt idx="42">
                    <c:v>7.4849999999999972E-2</c:v>
                  </c:pt>
                  <c:pt idx="43">
                    <c:v>7.7625000000000055E-2</c:v>
                  </c:pt>
                  <c:pt idx="44">
                    <c:v>0.17345500000000003</c:v>
                  </c:pt>
                  <c:pt idx="45">
                    <c:v>0.10444999999999993</c:v>
                  </c:pt>
                  <c:pt idx="46">
                    <c:v>5.8194999999999997E-2</c:v>
                  </c:pt>
                  <c:pt idx="47">
                    <c:v>5.3494999999999959E-2</c:v>
                  </c:pt>
                  <c:pt idx="48">
                    <c:v>2.937500000000004E-2</c:v>
                  </c:pt>
                  <c:pt idx="49">
                    <c:v>4.2000000000000037E-2</c:v>
                  </c:pt>
                  <c:pt idx="50">
                    <c:v>1.3624999999999998E-2</c:v>
                  </c:pt>
                  <c:pt idx="51">
                    <c:v>3.318500000000002E-2</c:v>
                  </c:pt>
                  <c:pt idx="52">
                    <c:v>1.9124999999999948E-2</c:v>
                  </c:pt>
                  <c:pt idx="53">
                    <c:v>4.1154999999999942E-2</c:v>
                  </c:pt>
                  <c:pt idx="54">
                    <c:v>4.793499999999995E-2</c:v>
                  </c:pt>
                  <c:pt idx="55">
                    <c:v>2.9629999999999934E-2</c:v>
                  </c:pt>
                  <c:pt idx="56">
                    <c:v>5.2494999999999958E-2</c:v>
                  </c:pt>
                  <c:pt idx="57">
                    <c:v>3.4270000000000023E-2</c:v>
                  </c:pt>
                  <c:pt idx="58">
                    <c:v>4.9644999999999939E-2</c:v>
                  </c:pt>
                  <c:pt idx="59">
                    <c:v>6.2334999999999918E-2</c:v>
                  </c:pt>
                  <c:pt idx="60">
                    <c:v>5.7124999999999981E-2</c:v>
                  </c:pt>
                  <c:pt idx="61">
                    <c:v>3.2805000000000084E-2</c:v>
                  </c:pt>
                  <c:pt idx="62">
                    <c:v>3.5525000000000029E-2</c:v>
                  </c:pt>
                  <c:pt idx="63">
                    <c:v>4.8895000000000022E-2</c:v>
                  </c:pt>
                  <c:pt idx="64">
                    <c:v>4.964500000000005E-2</c:v>
                  </c:pt>
                  <c:pt idx="65">
                    <c:v>0</c:v>
                  </c:pt>
                  <c:pt idx="66">
                    <c:v>8.3494999999999986E-2</c:v>
                  </c:pt>
                  <c:pt idx="67">
                    <c:v>4.4874999999999998E-2</c:v>
                  </c:pt>
                  <c:pt idx="68">
                    <c:v>3.6354999999999915E-2</c:v>
                  </c:pt>
                  <c:pt idx="69">
                    <c:v>4.4314999999999993E-2</c:v>
                  </c:pt>
                  <c:pt idx="70">
                    <c:v>2.7895000000000003E-2</c:v>
                  </c:pt>
                  <c:pt idx="71">
                    <c:v>2.9584999999999972E-2</c:v>
                  </c:pt>
                  <c:pt idx="72">
                    <c:v>3.2159999999999966E-2</c:v>
                  </c:pt>
                  <c:pt idx="73">
                    <c:v>0</c:v>
                  </c:pt>
                  <c:pt idx="74">
                    <c:v>5.7064999999999921E-2</c:v>
                  </c:pt>
                  <c:pt idx="75">
                    <c:v>4.8699999999999966E-2</c:v>
                  </c:pt>
                  <c:pt idx="76">
                    <c:v>6.1315000000000008E-2</c:v>
                  </c:pt>
                  <c:pt idx="77">
                    <c:v>4.9399999999999999E-2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numRef>
              <c:f>Sheet1!$A$1:$A$78</c:f>
              <c:numCache>
                <c:formatCode>General</c:formatCode>
                <c:ptCount val="7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</c:numCache>
            </c:numRef>
          </c:cat>
          <c:val>
            <c:numRef>
              <c:f>Sheet1!$B$1:$B$78</c:f>
              <c:numCache>
                <c:formatCode>General</c:formatCode>
                <c:ptCount val="78"/>
                <c:pt idx="1">
                  <c:v>1.34636</c:v>
                </c:pt>
                <c:pt idx="3">
                  <c:v>1.34636</c:v>
                </c:pt>
                <c:pt idx="4">
                  <c:v>1.3676299999999999</c:v>
                </c:pt>
                <c:pt idx="5">
                  <c:v>1.3875900000000001</c:v>
                </c:pt>
                <c:pt idx="6">
                  <c:v>1.3734900000000001</c:v>
                </c:pt>
                <c:pt idx="7">
                  <c:v>1.3637699999999999</c:v>
                </c:pt>
                <c:pt idx="8">
                  <c:v>1.4279500000000001</c:v>
                </c:pt>
                <c:pt idx="10">
                  <c:v>1.4631799999999999</c:v>
                </c:pt>
                <c:pt idx="11">
                  <c:v>1.4567699999999999</c:v>
                </c:pt>
                <c:pt idx="12">
                  <c:v>1.4022399999999999</c:v>
                </c:pt>
                <c:pt idx="13">
                  <c:v>1.4321299999999999</c:v>
                </c:pt>
                <c:pt idx="14">
                  <c:v>1.43113</c:v>
                </c:pt>
                <c:pt idx="16">
                  <c:v>1.48183</c:v>
                </c:pt>
                <c:pt idx="18">
                  <c:v>1.3133600000000001</c:v>
                </c:pt>
                <c:pt idx="19">
                  <c:v>1.3379099999999999</c:v>
                </c:pt>
                <c:pt idx="20">
                  <c:v>1.37493</c:v>
                </c:pt>
                <c:pt idx="21">
                  <c:v>1.47055</c:v>
                </c:pt>
                <c:pt idx="22">
                  <c:v>1.43258</c:v>
                </c:pt>
                <c:pt idx="23">
                  <c:v>1.3938200000000001</c:v>
                </c:pt>
                <c:pt idx="24">
                  <c:v>1.32803</c:v>
                </c:pt>
                <c:pt idx="25">
                  <c:v>1.3783300000000001</c:v>
                </c:pt>
                <c:pt idx="26">
                  <c:v>1.42052</c:v>
                </c:pt>
                <c:pt idx="27">
                  <c:v>1.45217</c:v>
                </c:pt>
                <c:pt idx="28">
                  <c:v>1.4441999999999999</c:v>
                </c:pt>
                <c:pt idx="29">
                  <c:v>1.40784</c:v>
                </c:pt>
                <c:pt idx="30">
                  <c:v>1.4362200000000001</c:v>
                </c:pt>
                <c:pt idx="31">
                  <c:v>1.3613500000000001</c:v>
                </c:pt>
                <c:pt idx="32">
                  <c:v>1.34246</c:v>
                </c:pt>
                <c:pt idx="33">
                  <c:v>1.3414299999999999</c:v>
                </c:pt>
                <c:pt idx="34">
                  <c:v>1.3042899999999999</c:v>
                </c:pt>
                <c:pt idx="36">
                  <c:v>1.35043</c:v>
                </c:pt>
                <c:pt idx="37">
                  <c:v>1.4314800000000001</c:v>
                </c:pt>
                <c:pt idx="38">
                  <c:v>1.22525</c:v>
                </c:pt>
                <c:pt idx="39">
                  <c:v>1.3713500000000001</c:v>
                </c:pt>
                <c:pt idx="40">
                  <c:v>1.3930499999999999</c:v>
                </c:pt>
                <c:pt idx="41">
                  <c:v>1.42536</c:v>
                </c:pt>
                <c:pt idx="42">
                  <c:v>1.33525</c:v>
                </c:pt>
                <c:pt idx="43">
                  <c:v>1.3457399999999999</c:v>
                </c:pt>
                <c:pt idx="44">
                  <c:v>1.43862</c:v>
                </c:pt>
                <c:pt idx="45">
                  <c:v>1.51444</c:v>
                </c:pt>
                <c:pt idx="46">
                  <c:v>1.4639</c:v>
                </c:pt>
                <c:pt idx="47">
                  <c:v>1.43316</c:v>
                </c:pt>
                <c:pt idx="48">
                  <c:v>1.4882500000000001</c:v>
                </c:pt>
                <c:pt idx="49">
                  <c:v>1.41632</c:v>
                </c:pt>
                <c:pt idx="50">
                  <c:v>1.5134399999999999</c:v>
                </c:pt>
                <c:pt idx="51">
                  <c:v>1.4477</c:v>
                </c:pt>
                <c:pt idx="52">
                  <c:v>1.3580700000000001</c:v>
                </c:pt>
                <c:pt idx="53">
                  <c:v>1.3967499999999999</c:v>
                </c:pt>
                <c:pt idx="54">
                  <c:v>1.36267</c:v>
                </c:pt>
                <c:pt idx="55">
                  <c:v>1.3623400000000001</c:v>
                </c:pt>
                <c:pt idx="56">
                  <c:v>1.5233300000000001</c:v>
                </c:pt>
                <c:pt idx="57">
                  <c:v>1.3702000000000001</c:v>
                </c:pt>
                <c:pt idx="58">
                  <c:v>1.3845000000000001</c:v>
                </c:pt>
                <c:pt idx="59">
                  <c:v>1.3935299999999999</c:v>
                </c:pt>
                <c:pt idx="60">
                  <c:v>1.3215300000000001</c:v>
                </c:pt>
                <c:pt idx="61">
                  <c:v>1.2948500000000001</c:v>
                </c:pt>
                <c:pt idx="62">
                  <c:v>1.44981</c:v>
                </c:pt>
                <c:pt idx="63">
                  <c:v>1.2673700000000001</c:v>
                </c:pt>
                <c:pt idx="64">
                  <c:v>1.2940499999999999</c:v>
                </c:pt>
                <c:pt idx="66">
                  <c:v>1.4903999999999999</c:v>
                </c:pt>
                <c:pt idx="67">
                  <c:v>1.40829</c:v>
                </c:pt>
                <c:pt idx="68">
                  <c:v>1.44876</c:v>
                </c:pt>
                <c:pt idx="69">
                  <c:v>1.3863399999999999</c:v>
                </c:pt>
                <c:pt idx="70">
                  <c:v>1.4097900000000001</c:v>
                </c:pt>
                <c:pt idx="71">
                  <c:v>1.4732099999999999</c:v>
                </c:pt>
                <c:pt idx="72">
                  <c:v>1.3483499999999999</c:v>
                </c:pt>
                <c:pt idx="74">
                  <c:v>1.4432700000000001</c:v>
                </c:pt>
                <c:pt idx="75">
                  <c:v>1.38934</c:v>
                </c:pt>
                <c:pt idx="76">
                  <c:v>1.3699300000000001</c:v>
                </c:pt>
                <c:pt idx="77">
                  <c:v>1.255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F6-4905-860B-8C14B87FFA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45423103"/>
        <c:axId val="645423583"/>
      </c:barChart>
      <c:catAx>
        <c:axId val="645423103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>
            <a:outerShdw blurRad="50800" dist="50800" dir="5400000" sx="1000" sy="1000" algn="ctr" rotWithShape="0">
              <a:srgbClr val="000000">
                <a:alpha val="43137"/>
              </a:srgbClr>
            </a:outerShdw>
          </a:effectLst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45423583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645423583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45423103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2_fitted!$C:$C</c:f>
                <c:numCache>
                  <c:formatCode>General</c:formatCode>
                  <c:ptCount val="1048576"/>
                  <c:pt idx="0">
                    <c:v>0</c:v>
                  </c:pt>
                  <c:pt idx="1">
                    <c:v>0.154255</c:v>
                  </c:pt>
                  <c:pt idx="2">
                    <c:v>0</c:v>
                  </c:pt>
                  <c:pt idx="3">
                    <c:v>0.16525200000000001</c:v>
                  </c:pt>
                  <c:pt idx="4">
                    <c:v>0.31178099999999997</c:v>
                  </c:pt>
                  <c:pt idx="5">
                    <c:v>0.50694600000000001</c:v>
                  </c:pt>
                  <c:pt idx="6">
                    <c:v>0.33517999999999998</c:v>
                  </c:pt>
                  <c:pt idx="7">
                    <c:v>0.15390100000000001</c:v>
                  </c:pt>
                  <c:pt idx="8">
                    <c:v>0.28321600000000002</c:v>
                  </c:pt>
                  <c:pt idx="9">
                    <c:v>0</c:v>
                  </c:pt>
                  <c:pt idx="10">
                    <c:v>0.55128299999999997</c:v>
                  </c:pt>
                  <c:pt idx="11">
                    <c:v>0.87049200000000004</c:v>
                  </c:pt>
                  <c:pt idx="12">
                    <c:v>0.50938300000000003</c:v>
                  </c:pt>
                  <c:pt idx="13">
                    <c:v>0.41551100000000002</c:v>
                  </c:pt>
                  <c:pt idx="14">
                    <c:v>2.0711900000000001</c:v>
                  </c:pt>
                  <c:pt idx="15">
                    <c:v>0</c:v>
                  </c:pt>
                  <c:pt idx="16">
                    <c:v>0.40687899999999999</c:v>
                  </c:pt>
                  <c:pt idx="17">
                    <c:v>0</c:v>
                  </c:pt>
                  <c:pt idx="18">
                    <c:v>0.24476800000000001</c:v>
                  </c:pt>
                  <c:pt idx="19">
                    <c:v>0.239232</c:v>
                  </c:pt>
                  <c:pt idx="20">
                    <c:v>0.679369</c:v>
                  </c:pt>
                  <c:pt idx="21">
                    <c:v>0.17704700000000001</c:v>
                  </c:pt>
                  <c:pt idx="22">
                    <c:v>0.134689</c:v>
                  </c:pt>
                  <c:pt idx="23">
                    <c:v>0.20874799999999999</c:v>
                  </c:pt>
                  <c:pt idx="24">
                    <c:v>0.39158100000000001</c:v>
                  </c:pt>
                  <c:pt idx="25">
                    <c:v>0.90202499999999997</c:v>
                  </c:pt>
                  <c:pt idx="26">
                    <c:v>0.416819</c:v>
                  </c:pt>
                  <c:pt idx="27">
                    <c:v>0.37332799999999999</c:v>
                  </c:pt>
                  <c:pt idx="28">
                    <c:v>0.36684</c:v>
                  </c:pt>
                  <c:pt idx="29">
                    <c:v>0.17422099999999999</c:v>
                  </c:pt>
                  <c:pt idx="30">
                    <c:v>0.81672900000000004</c:v>
                  </c:pt>
                  <c:pt idx="31">
                    <c:v>0.311778</c:v>
                  </c:pt>
                  <c:pt idx="32">
                    <c:v>0.175367</c:v>
                  </c:pt>
                  <c:pt idx="33">
                    <c:v>0.14927099999999999</c:v>
                  </c:pt>
                  <c:pt idx="34">
                    <c:v>0.15157899999999999</c:v>
                  </c:pt>
                  <c:pt idx="35">
                    <c:v>0</c:v>
                  </c:pt>
                  <c:pt idx="36">
                    <c:v>0.50095100000000004</c:v>
                  </c:pt>
                  <c:pt idx="37">
                    <c:v>0.370338</c:v>
                  </c:pt>
                  <c:pt idx="38">
                    <c:v>0.227381</c:v>
                  </c:pt>
                  <c:pt idx="39">
                    <c:v>0.455789</c:v>
                  </c:pt>
                  <c:pt idx="40">
                    <c:v>0.51071</c:v>
                  </c:pt>
                  <c:pt idx="41">
                    <c:v>1.02481</c:v>
                  </c:pt>
                  <c:pt idx="42">
                    <c:v>0.93003899999999995</c:v>
                  </c:pt>
                  <c:pt idx="43">
                    <c:v>0.52424499999999996</c:v>
                  </c:pt>
                  <c:pt idx="44">
                    <c:v>1.30525</c:v>
                  </c:pt>
                  <c:pt idx="45">
                    <c:v>0.95767800000000003</c:v>
                  </c:pt>
                  <c:pt idx="46">
                    <c:v>0.52240299999999995</c:v>
                  </c:pt>
                  <c:pt idx="47">
                    <c:v>0.49771500000000002</c:v>
                  </c:pt>
                  <c:pt idx="48">
                    <c:v>0.49425000000000002</c:v>
                  </c:pt>
                  <c:pt idx="49">
                    <c:v>0.44367200000000001</c:v>
                  </c:pt>
                  <c:pt idx="50">
                    <c:v>0.25665199999999999</c:v>
                  </c:pt>
                  <c:pt idx="51">
                    <c:v>0.28659099999999998</c:v>
                  </c:pt>
                  <c:pt idx="52">
                    <c:v>0.241843</c:v>
                  </c:pt>
                  <c:pt idx="53">
                    <c:v>0.14854600000000001</c:v>
                  </c:pt>
                  <c:pt idx="54">
                    <c:v>0.366506</c:v>
                  </c:pt>
                  <c:pt idx="55">
                    <c:v>0.28495900000000002</c:v>
                  </c:pt>
                  <c:pt idx="56">
                    <c:v>0.22074199999999999</c:v>
                  </c:pt>
                  <c:pt idx="57">
                    <c:v>0.276003</c:v>
                  </c:pt>
                  <c:pt idx="58">
                    <c:v>0.59287599999999996</c:v>
                  </c:pt>
                  <c:pt idx="59">
                    <c:v>0.31460300000000002</c:v>
                  </c:pt>
                  <c:pt idx="60">
                    <c:v>1.788</c:v>
                  </c:pt>
                  <c:pt idx="61">
                    <c:v>0.14966199999999999</c:v>
                  </c:pt>
                  <c:pt idx="62">
                    <c:v>0.33942099999999997</c:v>
                  </c:pt>
                  <c:pt idx="63">
                    <c:v>0.36105999999999999</c:v>
                  </c:pt>
                  <c:pt idx="64">
                    <c:v>0.34695700000000002</c:v>
                  </c:pt>
                  <c:pt idx="65">
                    <c:v>0</c:v>
                  </c:pt>
                  <c:pt idx="66">
                    <c:v>0.43356499999999998</c:v>
                  </c:pt>
                  <c:pt idx="67">
                    <c:v>0.35056799999999999</c:v>
                  </c:pt>
                  <c:pt idx="68">
                    <c:v>0.19800100000000001</c:v>
                  </c:pt>
                  <c:pt idx="69">
                    <c:v>0.45266800000000001</c:v>
                  </c:pt>
                  <c:pt idx="70">
                    <c:v>1.27616</c:v>
                  </c:pt>
                  <c:pt idx="71">
                    <c:v>0.20500399999999999</c:v>
                  </c:pt>
                  <c:pt idx="72">
                    <c:v>0.11260000000000001</c:v>
                  </c:pt>
                  <c:pt idx="73">
                    <c:v>0</c:v>
                  </c:pt>
                  <c:pt idx="74">
                    <c:v>0.201598</c:v>
                  </c:pt>
                  <c:pt idx="75">
                    <c:v>0.25652999999999998</c:v>
                  </c:pt>
                  <c:pt idx="76">
                    <c:v>0.63965000000000005</c:v>
                  </c:pt>
                  <c:pt idx="77">
                    <c:v>0.31710199999999999</c:v>
                  </c:pt>
                </c:numCache>
              </c:numRef>
            </c:plus>
            <c:minus>
              <c:numRef>
                <c:f>T2_fitted!$C:$C</c:f>
                <c:numCache>
                  <c:formatCode>General</c:formatCode>
                  <c:ptCount val="1048576"/>
                  <c:pt idx="0">
                    <c:v>0</c:v>
                  </c:pt>
                  <c:pt idx="1">
                    <c:v>0.154255</c:v>
                  </c:pt>
                  <c:pt idx="2">
                    <c:v>0</c:v>
                  </c:pt>
                  <c:pt idx="3">
                    <c:v>0.16525200000000001</c:v>
                  </c:pt>
                  <c:pt idx="4">
                    <c:v>0.31178099999999997</c:v>
                  </c:pt>
                  <c:pt idx="5">
                    <c:v>0.50694600000000001</c:v>
                  </c:pt>
                  <c:pt idx="6">
                    <c:v>0.33517999999999998</c:v>
                  </c:pt>
                  <c:pt idx="7">
                    <c:v>0.15390100000000001</c:v>
                  </c:pt>
                  <c:pt idx="8">
                    <c:v>0.28321600000000002</c:v>
                  </c:pt>
                  <c:pt idx="9">
                    <c:v>0</c:v>
                  </c:pt>
                  <c:pt idx="10">
                    <c:v>0.55128299999999997</c:v>
                  </c:pt>
                  <c:pt idx="11">
                    <c:v>0.87049200000000004</c:v>
                  </c:pt>
                  <c:pt idx="12">
                    <c:v>0.50938300000000003</c:v>
                  </c:pt>
                  <c:pt idx="13">
                    <c:v>0.41551100000000002</c:v>
                  </c:pt>
                  <c:pt idx="14">
                    <c:v>2.0711900000000001</c:v>
                  </c:pt>
                  <c:pt idx="15">
                    <c:v>0</c:v>
                  </c:pt>
                  <c:pt idx="16">
                    <c:v>0.40687899999999999</c:v>
                  </c:pt>
                  <c:pt idx="17">
                    <c:v>0</c:v>
                  </c:pt>
                  <c:pt idx="18">
                    <c:v>0.24476800000000001</c:v>
                  </c:pt>
                  <c:pt idx="19">
                    <c:v>0.239232</c:v>
                  </c:pt>
                  <c:pt idx="20">
                    <c:v>0.679369</c:v>
                  </c:pt>
                  <c:pt idx="21">
                    <c:v>0.17704700000000001</c:v>
                  </c:pt>
                  <c:pt idx="22">
                    <c:v>0.134689</c:v>
                  </c:pt>
                  <c:pt idx="23">
                    <c:v>0.20874799999999999</c:v>
                  </c:pt>
                  <c:pt idx="24">
                    <c:v>0.39158100000000001</c:v>
                  </c:pt>
                  <c:pt idx="25">
                    <c:v>0.90202499999999997</c:v>
                  </c:pt>
                  <c:pt idx="26">
                    <c:v>0.416819</c:v>
                  </c:pt>
                  <c:pt idx="27">
                    <c:v>0.37332799999999999</c:v>
                  </c:pt>
                  <c:pt idx="28">
                    <c:v>0.36684</c:v>
                  </c:pt>
                  <c:pt idx="29">
                    <c:v>0.17422099999999999</c:v>
                  </c:pt>
                  <c:pt idx="30">
                    <c:v>0.81672900000000004</c:v>
                  </c:pt>
                  <c:pt idx="31">
                    <c:v>0.311778</c:v>
                  </c:pt>
                  <c:pt idx="32">
                    <c:v>0.175367</c:v>
                  </c:pt>
                  <c:pt idx="33">
                    <c:v>0.14927099999999999</c:v>
                  </c:pt>
                  <c:pt idx="34">
                    <c:v>0.15157899999999999</c:v>
                  </c:pt>
                  <c:pt idx="35">
                    <c:v>0</c:v>
                  </c:pt>
                  <c:pt idx="36">
                    <c:v>0.50095100000000004</c:v>
                  </c:pt>
                  <c:pt idx="37">
                    <c:v>0.370338</c:v>
                  </c:pt>
                  <c:pt idx="38">
                    <c:v>0.227381</c:v>
                  </c:pt>
                  <c:pt idx="39">
                    <c:v>0.455789</c:v>
                  </c:pt>
                  <c:pt idx="40">
                    <c:v>0.51071</c:v>
                  </c:pt>
                  <c:pt idx="41">
                    <c:v>1.02481</c:v>
                  </c:pt>
                  <c:pt idx="42">
                    <c:v>0.93003899999999995</c:v>
                  </c:pt>
                  <c:pt idx="43">
                    <c:v>0.52424499999999996</c:v>
                  </c:pt>
                  <c:pt idx="44">
                    <c:v>1.30525</c:v>
                  </c:pt>
                  <c:pt idx="45">
                    <c:v>0.95767800000000003</c:v>
                  </c:pt>
                  <c:pt idx="46">
                    <c:v>0.52240299999999995</c:v>
                  </c:pt>
                  <c:pt idx="47">
                    <c:v>0.49771500000000002</c:v>
                  </c:pt>
                  <c:pt idx="48">
                    <c:v>0.49425000000000002</c:v>
                  </c:pt>
                  <c:pt idx="49">
                    <c:v>0.44367200000000001</c:v>
                  </c:pt>
                  <c:pt idx="50">
                    <c:v>0.25665199999999999</c:v>
                  </c:pt>
                  <c:pt idx="51">
                    <c:v>0.28659099999999998</c:v>
                  </c:pt>
                  <c:pt idx="52">
                    <c:v>0.241843</c:v>
                  </c:pt>
                  <c:pt idx="53">
                    <c:v>0.14854600000000001</c:v>
                  </c:pt>
                  <c:pt idx="54">
                    <c:v>0.366506</c:v>
                  </c:pt>
                  <c:pt idx="55">
                    <c:v>0.28495900000000002</c:v>
                  </c:pt>
                  <c:pt idx="56">
                    <c:v>0.22074199999999999</c:v>
                  </c:pt>
                  <c:pt idx="57">
                    <c:v>0.276003</c:v>
                  </c:pt>
                  <c:pt idx="58">
                    <c:v>0.59287599999999996</c:v>
                  </c:pt>
                  <c:pt idx="59">
                    <c:v>0.31460300000000002</c:v>
                  </c:pt>
                  <c:pt idx="60">
                    <c:v>1.788</c:v>
                  </c:pt>
                  <c:pt idx="61">
                    <c:v>0.14966199999999999</c:v>
                  </c:pt>
                  <c:pt idx="62">
                    <c:v>0.33942099999999997</c:v>
                  </c:pt>
                  <c:pt idx="63">
                    <c:v>0.36105999999999999</c:v>
                  </c:pt>
                  <c:pt idx="64">
                    <c:v>0.34695700000000002</c:v>
                  </c:pt>
                  <c:pt idx="65">
                    <c:v>0</c:v>
                  </c:pt>
                  <c:pt idx="66">
                    <c:v>0.43356499999999998</c:v>
                  </c:pt>
                  <c:pt idx="67">
                    <c:v>0.35056799999999999</c:v>
                  </c:pt>
                  <c:pt idx="68">
                    <c:v>0.19800100000000001</c:v>
                  </c:pt>
                  <c:pt idx="69">
                    <c:v>0.45266800000000001</c:v>
                  </c:pt>
                  <c:pt idx="70">
                    <c:v>1.27616</c:v>
                  </c:pt>
                  <c:pt idx="71">
                    <c:v>0.20500399999999999</c:v>
                  </c:pt>
                  <c:pt idx="72">
                    <c:v>0.11260000000000001</c:v>
                  </c:pt>
                  <c:pt idx="73">
                    <c:v>0</c:v>
                  </c:pt>
                  <c:pt idx="74">
                    <c:v>0.201598</c:v>
                  </c:pt>
                  <c:pt idx="75">
                    <c:v>0.25652999999999998</c:v>
                  </c:pt>
                  <c:pt idx="76">
                    <c:v>0.63965000000000005</c:v>
                  </c:pt>
                  <c:pt idx="77">
                    <c:v>0.317101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T2_fitted!$A$1:$A$78</c:f>
              <c:numCache>
                <c:formatCode>General</c:formatCode>
                <c:ptCount val="7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</c:numCache>
            </c:numRef>
          </c:cat>
          <c:val>
            <c:numRef>
              <c:f>T2_fitted!$B$1:$B$78</c:f>
              <c:numCache>
                <c:formatCode>General</c:formatCode>
                <c:ptCount val="78"/>
                <c:pt idx="0">
                  <c:v>0</c:v>
                </c:pt>
                <c:pt idx="1">
                  <c:v>9.4667899999999996</c:v>
                </c:pt>
                <c:pt idx="2">
                  <c:v>0</c:v>
                </c:pt>
                <c:pt idx="3">
                  <c:v>8.0226299999999995</c:v>
                </c:pt>
                <c:pt idx="4">
                  <c:v>8.7877299999999998</c:v>
                </c:pt>
                <c:pt idx="5">
                  <c:v>9.8996200000000005</c:v>
                </c:pt>
                <c:pt idx="6">
                  <c:v>8.9745399999999993</c:v>
                </c:pt>
                <c:pt idx="7">
                  <c:v>11.682600000000001</c:v>
                </c:pt>
                <c:pt idx="8">
                  <c:v>9.9686400000000006</c:v>
                </c:pt>
                <c:pt idx="9">
                  <c:v>0</c:v>
                </c:pt>
                <c:pt idx="10">
                  <c:v>9.4153400000000005</c:v>
                </c:pt>
                <c:pt idx="11">
                  <c:v>13.1648</c:v>
                </c:pt>
                <c:pt idx="12">
                  <c:v>8.9764599999999994</c:v>
                </c:pt>
                <c:pt idx="13">
                  <c:v>9.7707700000000006</c:v>
                </c:pt>
                <c:pt idx="14">
                  <c:v>20.242000000000001</c:v>
                </c:pt>
                <c:pt idx="15">
                  <c:v>0</c:v>
                </c:pt>
                <c:pt idx="16">
                  <c:v>8.7058300000000006</c:v>
                </c:pt>
                <c:pt idx="17">
                  <c:v>0</c:v>
                </c:pt>
                <c:pt idx="18">
                  <c:v>8.35853</c:v>
                </c:pt>
                <c:pt idx="19">
                  <c:v>7.41967</c:v>
                </c:pt>
                <c:pt idx="20">
                  <c:v>8.4635899999999999</c:v>
                </c:pt>
                <c:pt idx="21">
                  <c:v>9.9132099999999994</c:v>
                </c:pt>
                <c:pt idx="22">
                  <c:v>7.9927200000000003</c:v>
                </c:pt>
                <c:pt idx="23">
                  <c:v>8.0295500000000004</c:v>
                </c:pt>
                <c:pt idx="24">
                  <c:v>10.2462</c:v>
                </c:pt>
                <c:pt idx="25">
                  <c:v>8.1308100000000003</c:v>
                </c:pt>
                <c:pt idx="26">
                  <c:v>9.8610500000000005</c:v>
                </c:pt>
                <c:pt idx="27">
                  <c:v>9.6917399999999994</c:v>
                </c:pt>
                <c:pt idx="28">
                  <c:v>8.7905800000000003</c:v>
                </c:pt>
                <c:pt idx="29">
                  <c:v>9.0496400000000001</c:v>
                </c:pt>
                <c:pt idx="30">
                  <c:v>8.4028700000000001</c:v>
                </c:pt>
                <c:pt idx="31">
                  <c:v>8.5149699999999999</c:v>
                </c:pt>
                <c:pt idx="32">
                  <c:v>8.8248499999999996</c:v>
                </c:pt>
                <c:pt idx="33">
                  <c:v>8.0607500000000005</c:v>
                </c:pt>
                <c:pt idx="34">
                  <c:v>7.2154400000000001</c:v>
                </c:pt>
                <c:pt idx="35">
                  <c:v>0</c:v>
                </c:pt>
                <c:pt idx="36">
                  <c:v>17.769200000000001</c:v>
                </c:pt>
                <c:pt idx="37">
                  <c:v>10.3726</c:v>
                </c:pt>
                <c:pt idx="38">
                  <c:v>5.5531300000000003</c:v>
                </c:pt>
                <c:pt idx="39">
                  <c:v>7.7975599999999998</c:v>
                </c:pt>
                <c:pt idx="40">
                  <c:v>8.2259499999999992</c:v>
                </c:pt>
                <c:pt idx="41">
                  <c:v>6.8465400000000001</c:v>
                </c:pt>
                <c:pt idx="42">
                  <c:v>8.1238200000000003</c:v>
                </c:pt>
                <c:pt idx="43">
                  <c:v>8.7111999999999998</c:v>
                </c:pt>
                <c:pt idx="44">
                  <c:v>8.5428499999999996</c:v>
                </c:pt>
                <c:pt idx="45">
                  <c:v>8.3820300000000003</c:v>
                </c:pt>
                <c:pt idx="46">
                  <c:v>8.8283100000000001</c:v>
                </c:pt>
                <c:pt idx="47">
                  <c:v>8.7270099999999999</c:v>
                </c:pt>
                <c:pt idx="48">
                  <c:v>8.3431999999999995</c:v>
                </c:pt>
                <c:pt idx="49">
                  <c:v>12.5686</c:v>
                </c:pt>
                <c:pt idx="50">
                  <c:v>9.5520600000000009</c:v>
                </c:pt>
                <c:pt idx="51">
                  <c:v>9.0748300000000004</c:v>
                </c:pt>
                <c:pt idx="52">
                  <c:v>14.978400000000001</c:v>
                </c:pt>
                <c:pt idx="53">
                  <c:v>8.9684600000000003</c:v>
                </c:pt>
                <c:pt idx="54">
                  <c:v>21.508900000000001</c:v>
                </c:pt>
                <c:pt idx="55">
                  <c:v>9.13659</c:v>
                </c:pt>
                <c:pt idx="56">
                  <c:v>10.408899999999999</c:v>
                </c:pt>
                <c:pt idx="57">
                  <c:v>9.3081200000000006</c:v>
                </c:pt>
                <c:pt idx="58">
                  <c:v>8.0762999999999998</c:v>
                </c:pt>
                <c:pt idx="59">
                  <c:v>9.6971900000000009</c:v>
                </c:pt>
                <c:pt idx="60">
                  <c:v>9.6183200000000006</c:v>
                </c:pt>
                <c:pt idx="61">
                  <c:v>9.3708100000000005</c:v>
                </c:pt>
                <c:pt idx="62">
                  <c:v>7.2249600000000003</c:v>
                </c:pt>
                <c:pt idx="63">
                  <c:v>7.95235</c:v>
                </c:pt>
                <c:pt idx="64">
                  <c:v>9.3540600000000005</c:v>
                </c:pt>
                <c:pt idx="65">
                  <c:v>0</c:v>
                </c:pt>
                <c:pt idx="66">
                  <c:v>10.952999999999999</c:v>
                </c:pt>
                <c:pt idx="67">
                  <c:v>8.5093599999999991</c:v>
                </c:pt>
                <c:pt idx="68">
                  <c:v>9.4645799999999998</c:v>
                </c:pt>
                <c:pt idx="69">
                  <c:v>8.0114199999999993</c:v>
                </c:pt>
                <c:pt idx="70">
                  <c:v>7.6475299999999997</c:v>
                </c:pt>
                <c:pt idx="71">
                  <c:v>10.7104</c:v>
                </c:pt>
                <c:pt idx="72">
                  <c:v>12.950100000000001</c:v>
                </c:pt>
                <c:pt idx="73">
                  <c:v>0</c:v>
                </c:pt>
                <c:pt idx="74">
                  <c:v>8.1841200000000001</c:v>
                </c:pt>
                <c:pt idx="75">
                  <c:v>16.768000000000001</c:v>
                </c:pt>
                <c:pt idx="76">
                  <c:v>6.8411900000000001</c:v>
                </c:pt>
                <c:pt idx="77">
                  <c:v>3.25762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A4-4ABC-9496-4497C4A435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1204976"/>
        <c:axId val="91207376"/>
      </c:barChart>
      <c:catAx>
        <c:axId val="91204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207376"/>
        <c:crosses val="autoZero"/>
        <c:auto val="1"/>
        <c:lblAlgn val="ctr"/>
        <c:lblOffset val="100"/>
        <c:tickLblSkip val="5"/>
        <c:noMultiLvlLbl val="0"/>
      </c:catAx>
      <c:valAx>
        <c:axId val="91207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12049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>
                    <a:tint val="65000"/>
                  </a:schemeClr>
                </a:solidFill>
              </a:ln>
              <a:effectLst/>
            </c:spPr>
          </c:marker>
          <c:xVal>
            <c:multiLvlStrRef>
              <c:f>Sheet1!$F$1:$G$78</c:f>
              <c:multiLvlStrCache>
                <c:ptCount val="78"/>
                <c:lvl>
                  <c:pt idx="0">
                    <c:v>1Q</c:v>
                  </c:pt>
                  <c:pt idx="1">
                    <c:v> 2L   </c:v>
                  </c:pt>
                  <c:pt idx="2">
                    <c:v>3P</c:v>
                  </c:pt>
                  <c:pt idx="3">
                    <c:v>4V </c:v>
                  </c:pt>
                  <c:pt idx="4">
                    <c:v>5S </c:v>
                  </c:pt>
                  <c:pt idx="5">
                    <c:v>6N</c:v>
                  </c:pt>
                  <c:pt idx="6">
                    <c:v>7E</c:v>
                  </c:pt>
                  <c:pt idx="7">
                    <c:v> 8V</c:v>
                  </c:pt>
                  <c:pt idx="8">
                    <c:v> 9C </c:v>
                  </c:pt>
                  <c:pt idx="9">
                    <c:v>10P</c:v>
                  </c:pt>
                  <c:pt idx="10">
                    <c:v>11A </c:v>
                  </c:pt>
                  <c:pt idx="11">
                    <c:v>12G </c:v>
                  </c:pt>
                  <c:pt idx="12">
                    <c:v> 13L  </c:v>
                  </c:pt>
                  <c:pt idx="13">
                    <c:v>14R</c:v>
                  </c:pt>
                  <c:pt idx="14">
                    <c:v> 15T </c:v>
                  </c:pt>
                  <c:pt idx="15">
                    <c:v>16T  </c:v>
                  </c:pt>
                  <c:pt idx="16">
                    <c:v>17C  </c:v>
                  </c:pt>
                  <c:pt idx="17">
                    <c:v>18P</c:v>
                  </c:pt>
                  <c:pt idx="18">
                    <c:v>19A    </c:v>
                  </c:pt>
                  <c:pt idx="19">
                    <c:v>20G   </c:v>
                  </c:pt>
                  <c:pt idx="20">
                    <c:v>21T  </c:v>
                  </c:pt>
                  <c:pt idx="21">
                    <c:v>22D    </c:v>
                  </c:pt>
                  <c:pt idx="22">
                    <c:v>23G  </c:v>
                  </c:pt>
                  <c:pt idx="23">
                    <c:v>24V</c:v>
                  </c:pt>
                  <c:pt idx="24">
                    <c:v>25S</c:v>
                  </c:pt>
                  <c:pt idx="25">
                    <c:v>26R </c:v>
                  </c:pt>
                  <c:pt idx="26">
                    <c:v>27C</c:v>
                  </c:pt>
                  <c:pt idx="27">
                    <c:v>28S  </c:v>
                  </c:pt>
                  <c:pt idx="28">
                    <c:v>29I</c:v>
                  </c:pt>
                  <c:pt idx="29">
                    <c:v>30L</c:v>
                  </c:pt>
                  <c:pt idx="30">
                    <c:v>31N</c:v>
                  </c:pt>
                  <c:pt idx="31">
                    <c:v>32G</c:v>
                  </c:pt>
                  <c:pt idx="32">
                    <c:v>33Q</c:v>
                  </c:pt>
                  <c:pt idx="33">
                    <c:v>34N</c:v>
                  </c:pt>
                  <c:pt idx="34">
                    <c:v>35L</c:v>
                  </c:pt>
                  <c:pt idx="35">
                    <c:v>36C</c:v>
                  </c:pt>
                  <c:pt idx="36">
                    <c:v>37V</c:v>
                  </c:pt>
                  <c:pt idx="37">
                    <c:v>38I</c:v>
                  </c:pt>
                  <c:pt idx="38">
                    <c:v>39D</c:v>
                  </c:pt>
                  <c:pt idx="39">
                    <c:v>40C</c:v>
                  </c:pt>
                  <c:pt idx="40">
                    <c:v>41E</c:v>
                  </c:pt>
                  <c:pt idx="41">
                    <c:v>42A</c:v>
                  </c:pt>
                  <c:pt idx="42">
                    <c:v>43Q</c:v>
                  </c:pt>
                  <c:pt idx="43">
                    <c:v>44S</c:v>
                  </c:pt>
                  <c:pt idx="44">
                    <c:v>45T</c:v>
                  </c:pt>
                  <c:pt idx="45">
                    <c:v>46C</c:v>
                  </c:pt>
                  <c:pt idx="46">
                    <c:v>47R</c:v>
                  </c:pt>
                  <c:pt idx="47">
                    <c:v>48T</c:v>
                  </c:pt>
                  <c:pt idx="48">
                    <c:v>49Q</c:v>
                  </c:pt>
                  <c:pt idx="49">
                    <c:v>50C</c:v>
                  </c:pt>
                  <c:pt idx="50">
                    <c:v>51K</c:v>
                  </c:pt>
                  <c:pt idx="51">
                    <c:v>52Q</c:v>
                  </c:pt>
                  <c:pt idx="52">
                    <c:v>53Q</c:v>
                  </c:pt>
                  <c:pt idx="53">
                    <c:v>54G</c:v>
                  </c:pt>
                  <c:pt idx="54">
                    <c:v>55H</c:v>
                  </c:pt>
                  <c:pt idx="55">
                    <c:v>56I</c:v>
                  </c:pt>
                  <c:pt idx="56">
                    <c:v>57N</c:v>
                  </c:pt>
                  <c:pt idx="57">
                    <c:v>58G</c:v>
                  </c:pt>
                  <c:pt idx="58">
                    <c:v>59F</c:v>
                  </c:pt>
                  <c:pt idx="59">
                    <c:v>60C</c:v>
                  </c:pt>
                  <c:pt idx="60">
                    <c:v>61T</c:v>
                  </c:pt>
                  <c:pt idx="61">
                    <c:v>62I</c:v>
                  </c:pt>
                  <c:pt idx="62">
                    <c:v>63G</c:v>
                  </c:pt>
                  <c:pt idx="63">
                    <c:v>64D</c:v>
                  </c:pt>
                  <c:pt idx="64">
                    <c:v>65N</c:v>
                  </c:pt>
                  <c:pt idx="65">
                    <c:v>66P</c:v>
                  </c:pt>
                  <c:pt idx="66">
                    <c:v>67C</c:v>
                  </c:pt>
                  <c:pt idx="67">
                    <c:v>68I</c:v>
                  </c:pt>
                  <c:pt idx="68">
                    <c:v>69C</c:v>
                  </c:pt>
                  <c:pt idx="69">
                    <c:v>70S</c:v>
                  </c:pt>
                  <c:pt idx="70">
                    <c:v>71D</c:v>
                  </c:pt>
                  <c:pt idx="71">
                    <c:v>72I</c:v>
                  </c:pt>
                  <c:pt idx="72">
                    <c:v>73D</c:v>
                  </c:pt>
                  <c:pt idx="73">
                    <c:v>74P</c:v>
                  </c:pt>
                  <c:pt idx="74">
                    <c:v>75G</c:v>
                  </c:pt>
                  <c:pt idx="75">
                    <c:v>76F</c:v>
                  </c:pt>
                  <c:pt idx="76">
                    <c:v>77N</c:v>
                  </c:pt>
                  <c:pt idx="77">
                    <c:v>78N</c:v>
                  </c:pt>
                </c:lvl>
                <c:lvl>
                  <c:pt idx="0">
                    <c:v>1</c:v>
                  </c:pt>
                  <c:pt idx="1">
                    <c:v>2</c:v>
                  </c:pt>
                  <c:pt idx="2">
                    <c:v>3</c:v>
                  </c:pt>
                  <c:pt idx="3">
                    <c:v>4</c:v>
                  </c:pt>
                  <c:pt idx="4">
                    <c:v>5</c:v>
                  </c:pt>
                  <c:pt idx="5">
                    <c:v>6</c:v>
                  </c:pt>
                  <c:pt idx="6">
                    <c:v>7</c:v>
                  </c:pt>
                  <c:pt idx="7">
                    <c:v>8</c:v>
                  </c:pt>
                  <c:pt idx="8">
                    <c:v>9</c:v>
                  </c:pt>
                  <c:pt idx="9">
                    <c:v>10</c:v>
                  </c:pt>
                  <c:pt idx="10">
                    <c:v>11</c:v>
                  </c:pt>
                  <c:pt idx="11">
                    <c:v>12</c:v>
                  </c:pt>
                  <c:pt idx="12">
                    <c:v>13</c:v>
                  </c:pt>
                  <c:pt idx="13">
                    <c:v>14</c:v>
                  </c:pt>
                  <c:pt idx="14">
                    <c:v>15</c:v>
                  </c:pt>
                  <c:pt idx="15">
                    <c:v>16</c:v>
                  </c:pt>
                  <c:pt idx="16">
                    <c:v>17</c:v>
                  </c:pt>
                  <c:pt idx="17">
                    <c:v>18</c:v>
                  </c:pt>
                  <c:pt idx="18">
                    <c:v>19</c:v>
                  </c:pt>
                  <c:pt idx="19">
                    <c:v>20</c:v>
                  </c:pt>
                  <c:pt idx="20">
                    <c:v>21</c:v>
                  </c:pt>
                  <c:pt idx="21">
                    <c:v>22</c:v>
                  </c:pt>
                  <c:pt idx="22">
                    <c:v>23</c:v>
                  </c:pt>
                  <c:pt idx="23">
                    <c:v>24</c:v>
                  </c:pt>
                  <c:pt idx="24">
                    <c:v>25</c:v>
                  </c:pt>
                  <c:pt idx="25">
                    <c:v>26</c:v>
                  </c:pt>
                  <c:pt idx="26">
                    <c:v>27</c:v>
                  </c:pt>
                  <c:pt idx="27">
                    <c:v>28</c:v>
                  </c:pt>
                  <c:pt idx="28">
                    <c:v>29</c:v>
                  </c:pt>
                  <c:pt idx="29">
                    <c:v>30</c:v>
                  </c:pt>
                  <c:pt idx="30">
                    <c:v>31</c:v>
                  </c:pt>
                  <c:pt idx="31">
                    <c:v>32</c:v>
                  </c:pt>
                  <c:pt idx="32">
                    <c:v>33</c:v>
                  </c:pt>
                  <c:pt idx="33">
                    <c:v>34</c:v>
                  </c:pt>
                  <c:pt idx="34">
                    <c:v>35</c:v>
                  </c:pt>
                  <c:pt idx="35">
                    <c:v>36</c:v>
                  </c:pt>
                  <c:pt idx="36">
                    <c:v>37</c:v>
                  </c:pt>
                  <c:pt idx="37">
                    <c:v>38</c:v>
                  </c:pt>
                  <c:pt idx="38">
                    <c:v>39</c:v>
                  </c:pt>
                  <c:pt idx="39">
                    <c:v>40</c:v>
                  </c:pt>
                  <c:pt idx="40">
                    <c:v>41</c:v>
                  </c:pt>
                  <c:pt idx="41">
                    <c:v>42</c:v>
                  </c:pt>
                  <c:pt idx="42">
                    <c:v>43</c:v>
                  </c:pt>
                  <c:pt idx="43">
                    <c:v>44</c:v>
                  </c:pt>
                  <c:pt idx="44">
                    <c:v>45</c:v>
                  </c:pt>
                  <c:pt idx="45">
                    <c:v>46</c:v>
                  </c:pt>
                  <c:pt idx="46">
                    <c:v>47</c:v>
                  </c:pt>
                  <c:pt idx="47">
                    <c:v>48</c:v>
                  </c:pt>
                  <c:pt idx="48">
                    <c:v>49</c:v>
                  </c:pt>
                  <c:pt idx="49">
                    <c:v>50</c:v>
                  </c:pt>
                  <c:pt idx="50">
                    <c:v>51</c:v>
                  </c:pt>
                  <c:pt idx="51">
                    <c:v>52</c:v>
                  </c:pt>
                  <c:pt idx="52">
                    <c:v>53</c:v>
                  </c:pt>
                  <c:pt idx="53">
                    <c:v>54</c:v>
                  </c:pt>
                  <c:pt idx="54">
                    <c:v>55</c:v>
                  </c:pt>
                  <c:pt idx="55">
                    <c:v>56</c:v>
                  </c:pt>
                  <c:pt idx="56">
                    <c:v>57</c:v>
                  </c:pt>
                  <c:pt idx="57">
                    <c:v>58</c:v>
                  </c:pt>
                  <c:pt idx="58">
                    <c:v>59</c:v>
                  </c:pt>
                  <c:pt idx="59">
                    <c:v>60</c:v>
                  </c:pt>
                  <c:pt idx="60">
                    <c:v>61</c:v>
                  </c:pt>
                  <c:pt idx="61">
                    <c:v>62</c:v>
                  </c:pt>
                  <c:pt idx="62">
                    <c:v>63</c:v>
                  </c:pt>
                  <c:pt idx="63">
                    <c:v>64</c:v>
                  </c:pt>
                  <c:pt idx="64">
                    <c:v>65</c:v>
                  </c:pt>
                  <c:pt idx="65">
                    <c:v>66</c:v>
                  </c:pt>
                  <c:pt idx="66">
                    <c:v>67</c:v>
                  </c:pt>
                  <c:pt idx="67">
                    <c:v>68</c:v>
                  </c:pt>
                  <c:pt idx="68">
                    <c:v>69</c:v>
                  </c:pt>
                  <c:pt idx="69">
                    <c:v>70</c:v>
                  </c:pt>
                  <c:pt idx="70">
                    <c:v>71</c:v>
                  </c:pt>
                  <c:pt idx="71">
                    <c:v>72</c:v>
                  </c:pt>
                  <c:pt idx="72">
                    <c:v>73</c:v>
                  </c:pt>
                  <c:pt idx="73">
                    <c:v>74</c:v>
                  </c:pt>
                  <c:pt idx="74">
                    <c:v>75</c:v>
                  </c:pt>
                  <c:pt idx="75">
                    <c:v>76</c:v>
                  </c:pt>
                  <c:pt idx="76">
                    <c:v>77</c:v>
                  </c:pt>
                  <c:pt idx="77">
                    <c:v>78</c:v>
                  </c:pt>
                </c:lvl>
              </c:multiLvlStrCache>
            </c:multiLvlStrRef>
          </c:xVal>
          <c:yVal>
            <c:numRef>
              <c:f>Sheet1!$J$1:$J$78</c:f>
              <c:numCache>
                <c:formatCode>General</c:formatCode>
                <c:ptCount val="78"/>
                <c:pt idx="1">
                  <c:v>0.75896904985515801</c:v>
                </c:pt>
                <c:pt idx="3">
                  <c:v>0.80167116321253085</c:v>
                </c:pt>
                <c:pt idx="4">
                  <c:v>0.86717291402057339</c:v>
                </c:pt>
                <c:pt idx="5">
                  <c:v>0.84769806624063482</c:v>
                </c:pt>
                <c:pt idx="6">
                  <c:v>0.84567772603699931</c:v>
                </c:pt>
                <c:pt idx="7">
                  <c:v>0.77711194387558624</c:v>
                </c:pt>
                <c:pt idx="8">
                  <c:v>0.86306528688111206</c:v>
                </c:pt>
                <c:pt idx="10">
                  <c:v>0.8540984544098208</c:v>
                </c:pt>
                <c:pt idx="11">
                  <c:v>0.79186591621498392</c:v>
                </c:pt>
                <c:pt idx="12">
                  <c:v>0.83464614405642101</c:v>
                </c:pt>
                <c:pt idx="13">
                  <c:v>0.80275265931483486</c:v>
                </c:pt>
                <c:pt idx="14">
                  <c:v>0.8205254603493578</c:v>
                </c:pt>
                <c:pt idx="15">
                  <c:v>0.78963934598070307</c:v>
                </c:pt>
                <c:pt idx="16">
                  <c:v>0.83196097931200075</c:v>
                </c:pt>
                <c:pt idx="18">
                  <c:v>0.7601695539664779</c:v>
                </c:pt>
                <c:pt idx="19">
                  <c:v>0.74837063812810711</c:v>
                </c:pt>
                <c:pt idx="20">
                  <c:v>0.82671253204593698</c:v>
                </c:pt>
                <c:pt idx="21">
                  <c:v>0.86081088790115767</c:v>
                </c:pt>
                <c:pt idx="22">
                  <c:v>0.80599924851753479</c:v>
                </c:pt>
                <c:pt idx="23">
                  <c:v>0.84739472509820357</c:v>
                </c:pt>
                <c:pt idx="24">
                  <c:v>0.79326413824190511</c:v>
                </c:pt>
                <c:pt idx="25">
                  <c:v>0.85219730016743023</c:v>
                </c:pt>
                <c:pt idx="26">
                  <c:v>0.87888171287385686</c:v>
                </c:pt>
                <c:pt idx="27">
                  <c:v>0.8472031768759446</c:v>
                </c:pt>
                <c:pt idx="28">
                  <c:v>0.8607997874874268</c:v>
                </c:pt>
                <c:pt idx="29">
                  <c:v>0.84356136735949738</c:v>
                </c:pt>
                <c:pt idx="30">
                  <c:v>0.78778729901882305</c:v>
                </c:pt>
                <c:pt idx="31">
                  <c:v>0.78444552249745836</c:v>
                </c:pt>
                <c:pt idx="32">
                  <c:v>0.81188129772154283</c:v>
                </c:pt>
                <c:pt idx="33">
                  <c:v>0.82734702124171333</c:v>
                </c:pt>
                <c:pt idx="34">
                  <c:v>0.81417198081826114</c:v>
                </c:pt>
                <c:pt idx="36">
                  <c:v>0.84553144672007829</c:v>
                </c:pt>
                <c:pt idx="37">
                  <c:v>0.82378015502475133</c:v>
                </c:pt>
                <c:pt idx="38">
                  <c:v>0.41822995084327474</c:v>
                </c:pt>
                <c:pt idx="39">
                  <c:v>0.77864287145436617</c:v>
                </c:pt>
                <c:pt idx="40">
                  <c:v>0.78122703500850221</c:v>
                </c:pt>
                <c:pt idx="41">
                  <c:v>0.82935265369449829</c:v>
                </c:pt>
                <c:pt idx="42">
                  <c:v>0.72448762808108524</c:v>
                </c:pt>
                <c:pt idx="43">
                  <c:v>0.79483922267384632</c:v>
                </c:pt>
                <c:pt idx="44">
                  <c:v>0.8016550203226942</c:v>
                </c:pt>
                <c:pt idx="45">
                  <c:v>0.87376611320288866</c:v>
                </c:pt>
                <c:pt idx="46">
                  <c:v>0.87257315522989809</c:v>
                </c:pt>
                <c:pt idx="47">
                  <c:v>0.86620827905218978</c:v>
                </c:pt>
                <c:pt idx="48">
                  <c:v>0.86319541305910785</c:v>
                </c:pt>
                <c:pt idx="49">
                  <c:v>0.85943007970393381</c:v>
                </c:pt>
                <c:pt idx="50">
                  <c:v>0.87886440071835326</c:v>
                </c:pt>
                <c:pt idx="51">
                  <c:v>0.8565477126007669</c:v>
                </c:pt>
                <c:pt idx="52">
                  <c:v>0.84138908406984647</c:v>
                </c:pt>
                <c:pt idx="53">
                  <c:v>0.86659229760551071</c:v>
                </c:pt>
                <c:pt idx="54">
                  <c:v>0.8506431363975856</c:v>
                </c:pt>
                <c:pt idx="55">
                  <c:v>0.78606133318189697</c:v>
                </c:pt>
                <c:pt idx="56">
                  <c:v>0.86473906989459126</c:v>
                </c:pt>
                <c:pt idx="57">
                  <c:v>0.83580886053226522</c:v>
                </c:pt>
                <c:pt idx="58">
                  <c:v>0.8461149443063869</c:v>
                </c:pt>
                <c:pt idx="59">
                  <c:v>0.83271483230202736</c:v>
                </c:pt>
                <c:pt idx="60">
                  <c:v>0.81161299696259537</c:v>
                </c:pt>
                <c:pt idx="61">
                  <c:v>0.81413516355885185</c:v>
                </c:pt>
                <c:pt idx="62">
                  <c:v>0.77499613964227443</c:v>
                </c:pt>
                <c:pt idx="63">
                  <c:v>0.79071618273155608</c:v>
                </c:pt>
                <c:pt idx="64">
                  <c:v>0.80340762236043228</c:v>
                </c:pt>
                <c:pt idx="66">
                  <c:v>0.85722530373213501</c:v>
                </c:pt>
                <c:pt idx="67">
                  <c:v>0.85119501779500861</c:v>
                </c:pt>
                <c:pt idx="68">
                  <c:v>0.85052334992742629</c:v>
                </c:pt>
                <c:pt idx="69">
                  <c:v>0.87901924776845497</c:v>
                </c:pt>
                <c:pt idx="70">
                  <c:v>0.8679026089350933</c:v>
                </c:pt>
                <c:pt idx="71">
                  <c:v>0.87736331849998128</c:v>
                </c:pt>
                <c:pt idx="72">
                  <c:v>0.85675230860830831</c:v>
                </c:pt>
                <c:pt idx="74">
                  <c:v>0.84687740960771973</c:v>
                </c:pt>
                <c:pt idx="75">
                  <c:v>0.79518378315325289</c:v>
                </c:pt>
                <c:pt idx="76">
                  <c:v>0.71158252804422228</c:v>
                </c:pt>
                <c:pt idx="77">
                  <c:v>0.292304809828984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6EA-4B2A-8F76-093443DA3A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912704"/>
        <c:axId val="198902144"/>
      </c:scatterChart>
      <c:valAx>
        <c:axId val="198912704"/>
        <c:scaling>
          <c:orientation val="minMax"/>
          <c:max val="78"/>
          <c:min val="1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8902144"/>
        <c:crosses val="autoZero"/>
        <c:crossBetween val="midCat"/>
        <c:majorUnit val="5"/>
      </c:valAx>
      <c:valAx>
        <c:axId val="1989021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8912704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4">
  <a:schemeClr val="accent4"/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DA73A1-8095-4DDA-B9C7-729F42BC20B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7D04CA-656C-46D2-892D-D766C6175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5130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79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469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9986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031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7457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99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5663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729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8211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58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610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0E1D9-6D45-43E9-A2E5-443C7FF7FF0C}" type="datetimeFigureOut">
              <a:rPr kumimoji="1" lang="ja-JP" altLang="en-US" smtClean="0"/>
              <a:t>2025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DBCE7-D237-476B-A9E7-7CFB3FB32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278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FBAEC14-F958-7A5A-8C3D-6427D500843B}"/>
              </a:ext>
            </a:extLst>
          </p:cNvPr>
          <p:cNvSpPr txBox="1"/>
          <p:nvPr/>
        </p:nvSpPr>
        <p:spPr>
          <a:xfrm>
            <a:off x="222115" y="6771721"/>
            <a:ext cx="641377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analysis by RT-PCR in </a:t>
            </a:r>
            <a:r>
              <a:rPr lang="en-US" altLang="ja-JP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Nicotiana </a:t>
            </a:r>
            <a:r>
              <a:rPr lang="en-US" altLang="ja-JP" sz="1200" b="1" i="1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leaves agroinfiltrated with ChEC88 and BAS3 constructs.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(a) Transcriptional expression of ChEC88 and BAS3. (b) Transcriptional expression of ChNLP1. “–RT” and “+RT” denote reactions performed in the absence and presence of reverse transcriptase, respectively, to confirm RNA-specific amplification.</a:t>
            </a:r>
            <a:endParaRPr lang="ja-JP" altLang="ja-JP" sz="12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7" name="図 6" descr="屋内, モニター, 座る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AC31D0C2-3374-3D6A-3731-567F74E34E1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44" t="10945" r="41729" b="24178"/>
          <a:stretch/>
        </p:blipFill>
        <p:spPr>
          <a:xfrm>
            <a:off x="820924" y="2244650"/>
            <a:ext cx="2165737" cy="2966177"/>
          </a:xfrm>
          <a:prstGeom prst="rect">
            <a:avLst/>
          </a:prstGeom>
        </p:spPr>
      </p:pic>
      <p:pic>
        <p:nvPicPr>
          <p:cNvPr id="9" name="図 8" descr="座る, モニター, 写真, 開く が含まれている画像&#10;&#10;自動的に生成された説明">
            <a:extLst>
              <a:ext uri="{FF2B5EF4-FFF2-40B4-BE49-F238E27FC236}">
                <a16:creationId xmlns:a16="http://schemas.microsoft.com/office/drawing/2014/main" id="{4BAC2F5E-B45C-C28D-D150-147A4259437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16" t="5672" r="21182" b="16232"/>
          <a:stretch/>
        </p:blipFill>
        <p:spPr>
          <a:xfrm>
            <a:off x="3808711" y="2244648"/>
            <a:ext cx="2932270" cy="2966177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3EFC893-85F7-EDEF-3459-5DD2E38F9DB9}"/>
              </a:ext>
            </a:extLst>
          </p:cNvPr>
          <p:cNvSpPr txBox="1"/>
          <p:nvPr/>
        </p:nvSpPr>
        <p:spPr>
          <a:xfrm>
            <a:off x="500302" y="1225755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14533D8-7CCC-FA54-1FA0-2FF17B96B9D0}"/>
              </a:ext>
            </a:extLst>
          </p:cNvPr>
          <p:cNvSpPr txBox="1"/>
          <p:nvPr/>
        </p:nvSpPr>
        <p:spPr>
          <a:xfrm>
            <a:off x="3310512" y="1225755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FAAAD98-5508-B741-76A0-897792AB98F1}"/>
              </a:ext>
            </a:extLst>
          </p:cNvPr>
          <p:cNvSpPr txBox="1"/>
          <p:nvPr/>
        </p:nvSpPr>
        <p:spPr>
          <a:xfrm>
            <a:off x="1082704" y="3045268"/>
            <a:ext cx="638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-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3869D86-1000-F208-2DAE-CDC846D09F2E}"/>
              </a:ext>
            </a:extLst>
          </p:cNvPr>
          <p:cNvSpPr txBox="1"/>
          <p:nvPr/>
        </p:nvSpPr>
        <p:spPr>
          <a:xfrm>
            <a:off x="1948265" y="3045268"/>
            <a:ext cx="750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+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14FF66-03CE-A386-A05C-456742267670}"/>
              </a:ext>
            </a:extLst>
          </p:cNvPr>
          <p:cNvSpPr txBox="1"/>
          <p:nvPr/>
        </p:nvSpPr>
        <p:spPr>
          <a:xfrm>
            <a:off x="4255830" y="3045268"/>
            <a:ext cx="638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-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18CBBCB-0529-9027-2B84-7F68BB16D3E0}"/>
              </a:ext>
            </a:extLst>
          </p:cNvPr>
          <p:cNvSpPr txBox="1"/>
          <p:nvPr/>
        </p:nvSpPr>
        <p:spPr>
          <a:xfrm>
            <a:off x="5465857" y="3045268"/>
            <a:ext cx="750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+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FED185A-C702-5CAD-4BA5-0FCD615CCE6A}"/>
              </a:ext>
            </a:extLst>
          </p:cNvPr>
          <p:cNvSpPr txBox="1"/>
          <p:nvPr/>
        </p:nvSpPr>
        <p:spPr>
          <a:xfrm rot="18909837">
            <a:off x="1363570" y="5451063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449FB74-90A6-C935-4C96-6030892CD741}"/>
              </a:ext>
            </a:extLst>
          </p:cNvPr>
          <p:cNvSpPr txBox="1"/>
          <p:nvPr/>
        </p:nvSpPr>
        <p:spPr>
          <a:xfrm rot="18909837">
            <a:off x="1738718" y="545106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BAS3</a:t>
            </a:r>
            <a:endParaRPr kumimoji="1" lang="ja-JP" altLang="en-US" b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B19C611-5329-EA3A-547C-3B2451C23DE4}"/>
              </a:ext>
            </a:extLst>
          </p:cNvPr>
          <p:cNvSpPr txBox="1"/>
          <p:nvPr/>
        </p:nvSpPr>
        <p:spPr>
          <a:xfrm rot="18909837">
            <a:off x="555310" y="545106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5FC43C9-D521-D521-CE84-FCA7A4F4635F}"/>
              </a:ext>
            </a:extLst>
          </p:cNvPr>
          <p:cNvSpPr txBox="1"/>
          <p:nvPr/>
        </p:nvSpPr>
        <p:spPr>
          <a:xfrm rot="18909837">
            <a:off x="930458" y="5451061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BAS3</a:t>
            </a:r>
            <a:endParaRPr kumimoji="1" lang="ja-JP" altLang="en-US" b="1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79B027A-E8B1-D1F3-E90D-56761EABAE94}"/>
              </a:ext>
            </a:extLst>
          </p:cNvPr>
          <p:cNvSpPr txBox="1"/>
          <p:nvPr/>
        </p:nvSpPr>
        <p:spPr>
          <a:xfrm rot="18909837">
            <a:off x="5079718" y="5451063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B269CA0-C257-7775-B273-25323F92671F}"/>
              </a:ext>
            </a:extLst>
          </p:cNvPr>
          <p:cNvSpPr txBox="1"/>
          <p:nvPr/>
        </p:nvSpPr>
        <p:spPr>
          <a:xfrm rot="18909837">
            <a:off x="5454866" y="545106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BAS3</a:t>
            </a:r>
            <a:endParaRPr kumimoji="1" lang="ja-JP" altLang="en-US" b="1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E8382DD-5891-1521-4E46-9892B5807463}"/>
              </a:ext>
            </a:extLst>
          </p:cNvPr>
          <p:cNvSpPr txBox="1"/>
          <p:nvPr/>
        </p:nvSpPr>
        <p:spPr>
          <a:xfrm rot="18909837">
            <a:off x="4698309" y="5451063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GFP</a:t>
            </a:r>
            <a:endParaRPr kumimoji="1" lang="ja-JP" altLang="en-US" b="1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CA7D9FA-584F-0878-5712-E9044ED3549B}"/>
              </a:ext>
            </a:extLst>
          </p:cNvPr>
          <p:cNvSpPr txBox="1"/>
          <p:nvPr/>
        </p:nvSpPr>
        <p:spPr>
          <a:xfrm rot="18909837">
            <a:off x="3903500" y="545106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BF38822-2179-6189-31C4-BA7D6352522F}"/>
              </a:ext>
            </a:extLst>
          </p:cNvPr>
          <p:cNvSpPr txBox="1"/>
          <p:nvPr/>
        </p:nvSpPr>
        <p:spPr>
          <a:xfrm rot="18909837">
            <a:off x="4278648" y="5451061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BAS3</a:t>
            </a:r>
            <a:endParaRPr kumimoji="1" lang="ja-JP" altLang="en-US" b="1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ACCBCBD-CA91-A549-490E-DD52B0132683}"/>
              </a:ext>
            </a:extLst>
          </p:cNvPr>
          <p:cNvSpPr txBox="1"/>
          <p:nvPr/>
        </p:nvSpPr>
        <p:spPr>
          <a:xfrm rot="18909837">
            <a:off x="3522091" y="545106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GFP</a:t>
            </a:r>
            <a:endParaRPr kumimoji="1" lang="ja-JP" altLang="en-US" b="1"/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EA419646-A684-C896-9AFC-F95CC14DD951}"/>
              </a:ext>
            </a:extLst>
          </p:cNvPr>
          <p:cNvCxnSpPr>
            <a:cxnSpLocks/>
          </p:cNvCxnSpPr>
          <p:nvPr/>
        </p:nvCxnSpPr>
        <p:spPr>
          <a:xfrm>
            <a:off x="657467" y="4543724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64A3FD6-3325-B0D3-BC5B-D2BA35F4912E}"/>
              </a:ext>
            </a:extLst>
          </p:cNvPr>
          <p:cNvSpPr txBox="1"/>
          <p:nvPr/>
        </p:nvSpPr>
        <p:spPr>
          <a:xfrm>
            <a:off x="-48572" y="4359058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500bp</a:t>
            </a:r>
            <a:endParaRPr kumimoji="1" lang="ja-JP" altLang="en-US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DE78093E-BEF7-DA13-7487-7F6123E3ABDA}"/>
              </a:ext>
            </a:extLst>
          </p:cNvPr>
          <p:cNvCxnSpPr>
            <a:cxnSpLocks/>
          </p:cNvCxnSpPr>
          <p:nvPr/>
        </p:nvCxnSpPr>
        <p:spPr>
          <a:xfrm>
            <a:off x="657467" y="5036175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C48B95B-BFF7-344E-3D19-51DA4C3C02F2}"/>
              </a:ext>
            </a:extLst>
          </p:cNvPr>
          <p:cNvSpPr txBox="1"/>
          <p:nvPr/>
        </p:nvSpPr>
        <p:spPr>
          <a:xfrm>
            <a:off x="-48572" y="4851509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100bp</a:t>
            </a:r>
            <a:endParaRPr kumimoji="1" lang="ja-JP" altLang="en-US"/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FB802973-76FC-6919-A192-638135777870}"/>
              </a:ext>
            </a:extLst>
          </p:cNvPr>
          <p:cNvCxnSpPr>
            <a:cxnSpLocks/>
          </p:cNvCxnSpPr>
          <p:nvPr/>
        </p:nvCxnSpPr>
        <p:spPr>
          <a:xfrm>
            <a:off x="3649856" y="4543724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7556051-FB69-B17F-D856-7016C6E68D5C}"/>
              </a:ext>
            </a:extLst>
          </p:cNvPr>
          <p:cNvSpPr txBox="1"/>
          <p:nvPr/>
        </p:nvSpPr>
        <p:spPr>
          <a:xfrm>
            <a:off x="2956343" y="4359058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500bp</a:t>
            </a:r>
            <a:endParaRPr kumimoji="1" lang="ja-JP" altLang="en-US"/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809DD59-5350-774D-15B3-9A2E50E07376}"/>
              </a:ext>
            </a:extLst>
          </p:cNvPr>
          <p:cNvCxnSpPr>
            <a:cxnSpLocks/>
          </p:cNvCxnSpPr>
          <p:nvPr/>
        </p:nvCxnSpPr>
        <p:spPr>
          <a:xfrm>
            <a:off x="3649856" y="5036175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20996C5-9E31-3007-64EB-B6F4C43EC297}"/>
              </a:ext>
            </a:extLst>
          </p:cNvPr>
          <p:cNvSpPr txBox="1"/>
          <p:nvPr/>
        </p:nvSpPr>
        <p:spPr>
          <a:xfrm>
            <a:off x="2956343" y="4851509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100bp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20204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FBAEC14-F958-7A5A-8C3D-6427D500843B}"/>
              </a:ext>
            </a:extLst>
          </p:cNvPr>
          <p:cNvSpPr txBox="1"/>
          <p:nvPr/>
        </p:nvSpPr>
        <p:spPr>
          <a:xfrm>
            <a:off x="222115" y="9041530"/>
            <a:ext cx="641377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</a:t>
            </a:r>
            <a:r>
              <a:rPr lang="ja-JP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analysis by RT-PCR in </a:t>
            </a:r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cotiana </a:t>
            </a:r>
            <a:r>
              <a:rPr lang="en-US" altLang="ja-JP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ves agroinfiltrated with ChEC88 variant constructs. 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ranscriptional expression of ChEC88 variants. (b) Transcriptional expression of ChNLP1. “–RT” and “+RT” denote reactions performed in the absence and presence of reverse transcriptase, respectively, to ensure RNA-specific amplification.</a:t>
            </a:r>
            <a:endParaRPr lang="ja-JP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FB802973-76FC-6919-A192-638135777870}"/>
              </a:ext>
            </a:extLst>
          </p:cNvPr>
          <p:cNvCxnSpPr>
            <a:cxnSpLocks/>
          </p:cNvCxnSpPr>
          <p:nvPr/>
        </p:nvCxnSpPr>
        <p:spPr>
          <a:xfrm>
            <a:off x="751466" y="3421427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7556051-FB69-B17F-D856-7016C6E68D5C}"/>
              </a:ext>
            </a:extLst>
          </p:cNvPr>
          <p:cNvSpPr txBox="1"/>
          <p:nvPr/>
        </p:nvSpPr>
        <p:spPr>
          <a:xfrm>
            <a:off x="1" y="3254606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500bp</a:t>
            </a:r>
            <a:endParaRPr kumimoji="1" lang="ja-JP" altLang="en-US"/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809DD59-5350-774D-15B3-9A2E50E07376}"/>
              </a:ext>
            </a:extLst>
          </p:cNvPr>
          <p:cNvCxnSpPr>
            <a:cxnSpLocks/>
          </p:cNvCxnSpPr>
          <p:nvPr/>
        </p:nvCxnSpPr>
        <p:spPr>
          <a:xfrm>
            <a:off x="751466" y="3998956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20996C5-9E31-3007-64EB-B6F4C43EC297}"/>
              </a:ext>
            </a:extLst>
          </p:cNvPr>
          <p:cNvSpPr txBox="1"/>
          <p:nvPr/>
        </p:nvSpPr>
        <p:spPr>
          <a:xfrm>
            <a:off x="0" y="3792761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100bp</a:t>
            </a:r>
            <a:endParaRPr kumimoji="1" lang="ja-JP" altLang="en-US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4D33114-413E-A5AA-889D-D2589DA22816}"/>
              </a:ext>
            </a:extLst>
          </p:cNvPr>
          <p:cNvSpPr txBox="1"/>
          <p:nvPr/>
        </p:nvSpPr>
        <p:spPr>
          <a:xfrm rot="18909837">
            <a:off x="3464517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ChEC88</a:t>
            </a:r>
            <a:endParaRPr kumimoji="1" lang="ja-JP" altLang="en-US" sz="1600" b="1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69CFC1B-CA8E-FB6F-7580-3E88CF1F4FF4}"/>
              </a:ext>
            </a:extLst>
          </p:cNvPr>
          <p:cNvSpPr txBox="1"/>
          <p:nvPr/>
        </p:nvSpPr>
        <p:spPr>
          <a:xfrm rot="18909837">
            <a:off x="3179716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GFP</a:t>
            </a:r>
            <a:endParaRPr kumimoji="1" lang="ja-JP" altLang="en-US" sz="1600" b="1"/>
          </a:p>
        </p:txBody>
      </p:sp>
      <p:pic>
        <p:nvPicPr>
          <p:cNvPr id="5" name="図 4" descr="コンピューターの画面&#10;&#10;自動的に生成された説明">
            <a:extLst>
              <a:ext uri="{FF2B5EF4-FFF2-40B4-BE49-F238E27FC236}">
                <a16:creationId xmlns:a16="http://schemas.microsoft.com/office/drawing/2014/main" id="{ADFEB714-F821-D7C9-D508-113133FC38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8" t="12196" r="24675" b="22599"/>
          <a:stretch/>
        </p:blipFill>
        <p:spPr>
          <a:xfrm>
            <a:off x="897570" y="431839"/>
            <a:ext cx="5654554" cy="3843030"/>
          </a:xfrm>
          <a:prstGeom prst="rect">
            <a:avLst/>
          </a:prstGeom>
        </p:spPr>
      </p:pic>
      <p:pic>
        <p:nvPicPr>
          <p:cNvPr id="9" name="図 8" descr="コンピューターの画面&#10;&#10;自動的に生成された説明">
            <a:extLst>
              <a:ext uri="{FF2B5EF4-FFF2-40B4-BE49-F238E27FC236}">
                <a16:creationId xmlns:a16="http://schemas.microsoft.com/office/drawing/2014/main" id="{74CC4876-2C39-CD87-C700-24F8CDF1B56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6" t="18829" r="19496" b="22832"/>
          <a:stretch/>
        </p:blipFill>
        <p:spPr>
          <a:xfrm>
            <a:off x="897570" y="5123145"/>
            <a:ext cx="5654555" cy="3227057"/>
          </a:xfrm>
          <a:prstGeom prst="rect">
            <a:avLst/>
          </a:prstGeom>
        </p:spPr>
      </p:pic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A526EFAC-6316-B942-A242-4AC9FB3DD221}"/>
              </a:ext>
            </a:extLst>
          </p:cNvPr>
          <p:cNvSpPr txBox="1"/>
          <p:nvPr/>
        </p:nvSpPr>
        <p:spPr>
          <a:xfrm rot="18909837">
            <a:off x="3749318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All 6A</a:t>
            </a:r>
            <a:endParaRPr kumimoji="1" lang="ja-JP" altLang="en-US" sz="1600" b="1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BDA88D5-93E4-FEA0-472F-5DF4F1B22B0E}"/>
              </a:ext>
            </a:extLst>
          </p:cNvPr>
          <p:cNvSpPr txBox="1"/>
          <p:nvPr/>
        </p:nvSpPr>
        <p:spPr>
          <a:xfrm rot="18909837">
            <a:off x="4034119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L2A</a:t>
            </a:r>
            <a:endParaRPr kumimoji="1" lang="ja-JP" altLang="en-US" sz="1600" b="1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A50DA62F-3E17-7D94-7534-99F576FBE039}"/>
              </a:ext>
            </a:extLst>
          </p:cNvPr>
          <p:cNvSpPr txBox="1"/>
          <p:nvPr/>
        </p:nvSpPr>
        <p:spPr>
          <a:xfrm rot="18909837">
            <a:off x="4318920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V4A</a:t>
            </a:r>
            <a:endParaRPr kumimoji="1" lang="ja-JP" altLang="en-US" sz="1600" b="1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514E658-6D12-3015-0A8E-92E190218CEA}"/>
              </a:ext>
            </a:extLst>
          </p:cNvPr>
          <p:cNvSpPr txBox="1"/>
          <p:nvPr/>
        </p:nvSpPr>
        <p:spPr>
          <a:xfrm rot="18909837">
            <a:off x="4603721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N6A</a:t>
            </a:r>
            <a:endParaRPr kumimoji="1" lang="ja-JP" altLang="en-US" sz="1600" b="1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519390B7-6BC9-D1CA-B7B1-C1CD975E06F3}"/>
              </a:ext>
            </a:extLst>
          </p:cNvPr>
          <p:cNvSpPr txBox="1"/>
          <p:nvPr/>
        </p:nvSpPr>
        <p:spPr>
          <a:xfrm rot="18909837">
            <a:off x="4888522" y="8558052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Q53A</a:t>
            </a:r>
            <a:endParaRPr kumimoji="1" lang="ja-JP" altLang="en-US" sz="1600" b="1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5FE36CF-812A-7681-797D-091EFAD91FCE}"/>
              </a:ext>
            </a:extLst>
          </p:cNvPr>
          <p:cNvSpPr txBox="1"/>
          <p:nvPr/>
        </p:nvSpPr>
        <p:spPr>
          <a:xfrm rot="18909837">
            <a:off x="5173323" y="8558052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H55A</a:t>
            </a:r>
            <a:endParaRPr kumimoji="1" lang="ja-JP" altLang="en-US" sz="1600" b="1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CA1684BF-21EC-66F5-20DE-9BFEFEBF4753}"/>
              </a:ext>
            </a:extLst>
          </p:cNvPr>
          <p:cNvSpPr txBox="1"/>
          <p:nvPr/>
        </p:nvSpPr>
        <p:spPr>
          <a:xfrm rot="18909837">
            <a:off x="5458124" y="8558052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D71A</a:t>
            </a:r>
            <a:endParaRPr kumimoji="1" lang="ja-JP" altLang="en-US" sz="1600" b="1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261F00E-B572-D77B-240B-F8C70FD4067E}"/>
              </a:ext>
            </a:extLst>
          </p:cNvPr>
          <p:cNvSpPr txBox="1"/>
          <p:nvPr/>
        </p:nvSpPr>
        <p:spPr>
          <a:xfrm rot="18909837">
            <a:off x="828557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ChEC88</a:t>
            </a:r>
            <a:endParaRPr kumimoji="1" lang="ja-JP" altLang="en-US" sz="1600" b="1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A42ED823-BCE7-6C83-BB52-EE75D5F12863}"/>
              </a:ext>
            </a:extLst>
          </p:cNvPr>
          <p:cNvSpPr txBox="1"/>
          <p:nvPr/>
        </p:nvSpPr>
        <p:spPr>
          <a:xfrm rot="18909837">
            <a:off x="543756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GFP</a:t>
            </a:r>
            <a:endParaRPr kumimoji="1" lang="ja-JP" altLang="en-US" sz="1600" b="1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8A7CE6F-A24E-9BAB-A26A-9EB65AB35E13}"/>
              </a:ext>
            </a:extLst>
          </p:cNvPr>
          <p:cNvSpPr txBox="1"/>
          <p:nvPr/>
        </p:nvSpPr>
        <p:spPr>
          <a:xfrm rot="18909837">
            <a:off x="1113358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All 6A</a:t>
            </a:r>
            <a:endParaRPr kumimoji="1" lang="ja-JP" altLang="en-US" sz="1600" b="1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BDCD05D-96BB-C72B-B79A-7DBFD7DAF3ED}"/>
              </a:ext>
            </a:extLst>
          </p:cNvPr>
          <p:cNvSpPr txBox="1"/>
          <p:nvPr/>
        </p:nvSpPr>
        <p:spPr>
          <a:xfrm rot="18909837">
            <a:off x="1398159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L2A</a:t>
            </a:r>
            <a:endParaRPr kumimoji="1" lang="ja-JP" altLang="en-US" sz="1600" b="1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684CFC01-C8EE-CB8E-B7DD-F4508A01CCB2}"/>
              </a:ext>
            </a:extLst>
          </p:cNvPr>
          <p:cNvSpPr txBox="1"/>
          <p:nvPr/>
        </p:nvSpPr>
        <p:spPr>
          <a:xfrm rot="18909837">
            <a:off x="1682960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V4A</a:t>
            </a:r>
            <a:endParaRPr kumimoji="1" lang="ja-JP" altLang="en-US" sz="1600" b="1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BF8F9593-CFD9-7363-2777-A0D8D0CCB853}"/>
              </a:ext>
            </a:extLst>
          </p:cNvPr>
          <p:cNvSpPr txBox="1"/>
          <p:nvPr/>
        </p:nvSpPr>
        <p:spPr>
          <a:xfrm rot="18909837">
            <a:off x="1967761" y="8558053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N6A</a:t>
            </a:r>
            <a:endParaRPr kumimoji="1" lang="ja-JP" altLang="en-US" sz="1600" b="1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AA4E3157-416C-568A-7356-BF0238EA4757}"/>
              </a:ext>
            </a:extLst>
          </p:cNvPr>
          <p:cNvSpPr txBox="1"/>
          <p:nvPr/>
        </p:nvSpPr>
        <p:spPr>
          <a:xfrm rot="18909837">
            <a:off x="2252562" y="8558052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Q53A</a:t>
            </a:r>
            <a:endParaRPr kumimoji="1" lang="ja-JP" altLang="en-US" sz="1600" b="1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510ACFC6-62BD-1ADC-67C8-08D18DB8C559}"/>
              </a:ext>
            </a:extLst>
          </p:cNvPr>
          <p:cNvSpPr txBox="1"/>
          <p:nvPr/>
        </p:nvSpPr>
        <p:spPr>
          <a:xfrm rot="18909837">
            <a:off x="2537363" y="8558052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H55A</a:t>
            </a:r>
            <a:endParaRPr kumimoji="1" lang="ja-JP" altLang="en-US" sz="1600" b="1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E1DDD1AF-5BB8-0A83-4C69-B2BCC4D3548D}"/>
              </a:ext>
            </a:extLst>
          </p:cNvPr>
          <p:cNvSpPr txBox="1"/>
          <p:nvPr/>
        </p:nvSpPr>
        <p:spPr>
          <a:xfrm rot="18909837">
            <a:off x="2822164" y="8558052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D71A</a:t>
            </a:r>
            <a:endParaRPr kumimoji="1" lang="ja-JP" altLang="en-US" sz="1600" b="1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5B3D2545-4973-52CE-C17C-BD3E5DE8F715}"/>
              </a:ext>
            </a:extLst>
          </p:cNvPr>
          <p:cNvSpPr txBox="1"/>
          <p:nvPr/>
        </p:nvSpPr>
        <p:spPr>
          <a:xfrm rot="18909837">
            <a:off x="3252466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ChEC88</a:t>
            </a:r>
            <a:endParaRPr kumimoji="1" lang="ja-JP" altLang="en-US" sz="1600" b="1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14A32EA-DAD2-309C-5FA8-8F474080CA08}"/>
              </a:ext>
            </a:extLst>
          </p:cNvPr>
          <p:cNvSpPr txBox="1"/>
          <p:nvPr/>
        </p:nvSpPr>
        <p:spPr>
          <a:xfrm rot="18909837">
            <a:off x="3537267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All 6A</a:t>
            </a:r>
            <a:endParaRPr kumimoji="1" lang="ja-JP" altLang="en-US" sz="1600" b="1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92E19861-C3A3-2CA0-9642-E99A01A0D3D0}"/>
              </a:ext>
            </a:extLst>
          </p:cNvPr>
          <p:cNvSpPr txBox="1"/>
          <p:nvPr/>
        </p:nvSpPr>
        <p:spPr>
          <a:xfrm rot="18909837">
            <a:off x="3822068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L2A</a:t>
            </a:r>
            <a:endParaRPr kumimoji="1" lang="ja-JP" altLang="en-US" sz="1600" b="1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501A37FC-5DFB-8C72-4C0B-CC8C497A0C2E}"/>
              </a:ext>
            </a:extLst>
          </p:cNvPr>
          <p:cNvSpPr txBox="1"/>
          <p:nvPr/>
        </p:nvSpPr>
        <p:spPr>
          <a:xfrm rot="18909837">
            <a:off x="4106869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V4A</a:t>
            </a:r>
            <a:endParaRPr kumimoji="1" lang="ja-JP" altLang="en-US" sz="1600" b="1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21EE374C-6114-8EEC-AE5C-CFCAC834AA03}"/>
              </a:ext>
            </a:extLst>
          </p:cNvPr>
          <p:cNvSpPr txBox="1"/>
          <p:nvPr/>
        </p:nvSpPr>
        <p:spPr>
          <a:xfrm rot="18909837">
            <a:off x="4391670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N6A</a:t>
            </a:r>
            <a:endParaRPr kumimoji="1" lang="ja-JP" altLang="en-US" sz="1600" b="1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5E8AF194-62BE-2D19-50CB-3FB7A641EA76}"/>
              </a:ext>
            </a:extLst>
          </p:cNvPr>
          <p:cNvSpPr txBox="1"/>
          <p:nvPr/>
        </p:nvSpPr>
        <p:spPr>
          <a:xfrm rot="18909837">
            <a:off x="4676471" y="4482718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Q53A</a:t>
            </a:r>
            <a:endParaRPr kumimoji="1" lang="ja-JP" altLang="en-US" sz="1600" b="1"/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34CC4D69-5C09-EA83-2E43-86C5AA4583FF}"/>
              </a:ext>
            </a:extLst>
          </p:cNvPr>
          <p:cNvSpPr txBox="1"/>
          <p:nvPr/>
        </p:nvSpPr>
        <p:spPr>
          <a:xfrm rot="18909837">
            <a:off x="4961272" y="4482718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H55A</a:t>
            </a:r>
            <a:endParaRPr kumimoji="1" lang="ja-JP" altLang="en-US" sz="1600" b="1"/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CCE85CDF-8938-3041-9219-9148B1B583B9}"/>
              </a:ext>
            </a:extLst>
          </p:cNvPr>
          <p:cNvSpPr txBox="1"/>
          <p:nvPr/>
        </p:nvSpPr>
        <p:spPr>
          <a:xfrm rot="18909837">
            <a:off x="5246073" y="4482718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D71A</a:t>
            </a:r>
            <a:endParaRPr kumimoji="1" lang="ja-JP" altLang="en-US" sz="1600" b="1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4797845D-DF95-341B-4D2A-B41BDCB1C630}"/>
              </a:ext>
            </a:extLst>
          </p:cNvPr>
          <p:cNvSpPr txBox="1"/>
          <p:nvPr/>
        </p:nvSpPr>
        <p:spPr>
          <a:xfrm rot="18909837">
            <a:off x="630138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ChEC88</a:t>
            </a:r>
            <a:endParaRPr kumimoji="1" lang="ja-JP" altLang="en-US" sz="1600" b="1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392E0999-8467-77FB-BA92-B84B81C33A96}"/>
              </a:ext>
            </a:extLst>
          </p:cNvPr>
          <p:cNvSpPr txBox="1"/>
          <p:nvPr/>
        </p:nvSpPr>
        <p:spPr>
          <a:xfrm rot="18909837">
            <a:off x="914939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All 6A</a:t>
            </a:r>
            <a:endParaRPr kumimoji="1" lang="ja-JP" altLang="en-US" sz="1600" b="1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01B7DA62-9058-2BFA-0A55-4A8D8D0805E8}"/>
              </a:ext>
            </a:extLst>
          </p:cNvPr>
          <p:cNvSpPr txBox="1"/>
          <p:nvPr/>
        </p:nvSpPr>
        <p:spPr>
          <a:xfrm rot="18909837">
            <a:off x="1199740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L2A</a:t>
            </a:r>
            <a:endParaRPr kumimoji="1" lang="ja-JP" altLang="en-US" sz="1600" b="1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A32DF8F5-B0BF-F69E-148E-28BCC06DDD7A}"/>
              </a:ext>
            </a:extLst>
          </p:cNvPr>
          <p:cNvSpPr txBox="1"/>
          <p:nvPr/>
        </p:nvSpPr>
        <p:spPr>
          <a:xfrm rot="18909837">
            <a:off x="1484541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V4A</a:t>
            </a:r>
            <a:endParaRPr kumimoji="1" lang="ja-JP" altLang="en-US" sz="1600" b="1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D39DD738-4C13-0F13-D724-A28907F7A892}"/>
              </a:ext>
            </a:extLst>
          </p:cNvPr>
          <p:cNvSpPr txBox="1"/>
          <p:nvPr/>
        </p:nvSpPr>
        <p:spPr>
          <a:xfrm rot="18909837">
            <a:off x="1769342" y="4482719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N6A</a:t>
            </a:r>
            <a:endParaRPr kumimoji="1" lang="ja-JP" altLang="en-US" sz="1600" b="1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183C9E42-BDDD-5E86-68D0-68B3C1DF321E}"/>
              </a:ext>
            </a:extLst>
          </p:cNvPr>
          <p:cNvSpPr txBox="1"/>
          <p:nvPr/>
        </p:nvSpPr>
        <p:spPr>
          <a:xfrm rot="18909837">
            <a:off x="2054143" y="4482718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Q53A</a:t>
            </a:r>
            <a:endParaRPr kumimoji="1" lang="ja-JP" altLang="en-US" sz="1600" b="1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1A0A41B2-C41A-4493-3529-7A77081F6392}"/>
              </a:ext>
            </a:extLst>
          </p:cNvPr>
          <p:cNvSpPr txBox="1"/>
          <p:nvPr/>
        </p:nvSpPr>
        <p:spPr>
          <a:xfrm rot="18909837">
            <a:off x="2338944" y="4482718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H55A</a:t>
            </a:r>
            <a:endParaRPr kumimoji="1" lang="ja-JP" altLang="en-US" sz="1600" b="1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BCFD8443-F534-1F1A-FEC9-AAB1583C34CF}"/>
              </a:ext>
            </a:extLst>
          </p:cNvPr>
          <p:cNvSpPr txBox="1"/>
          <p:nvPr/>
        </p:nvSpPr>
        <p:spPr>
          <a:xfrm rot="18909837">
            <a:off x="2623745" y="4482718"/>
            <a:ext cx="97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b="1"/>
              <a:t>D71A</a:t>
            </a:r>
            <a:endParaRPr kumimoji="1" lang="ja-JP" altLang="en-US" sz="1600" b="1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B352E976-B3CD-D4F3-18C1-8B66630B5AF1}"/>
              </a:ext>
            </a:extLst>
          </p:cNvPr>
          <p:cNvSpPr txBox="1"/>
          <p:nvPr/>
        </p:nvSpPr>
        <p:spPr>
          <a:xfrm>
            <a:off x="1906175" y="1193684"/>
            <a:ext cx="638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-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5D8F7005-C829-0E54-F815-9529CA9AA88D}"/>
              </a:ext>
            </a:extLst>
          </p:cNvPr>
          <p:cNvSpPr txBox="1"/>
          <p:nvPr/>
        </p:nvSpPr>
        <p:spPr>
          <a:xfrm>
            <a:off x="4639308" y="1193684"/>
            <a:ext cx="750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+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9C81D2C-A466-BAC5-7AAA-E9F21F2E902F}"/>
              </a:ext>
            </a:extLst>
          </p:cNvPr>
          <p:cNvSpPr txBox="1"/>
          <p:nvPr/>
        </p:nvSpPr>
        <p:spPr>
          <a:xfrm>
            <a:off x="1906175" y="5962569"/>
            <a:ext cx="638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-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22251EAE-70CD-01D9-0685-F35E8728886D}"/>
              </a:ext>
            </a:extLst>
          </p:cNvPr>
          <p:cNvSpPr txBox="1"/>
          <p:nvPr/>
        </p:nvSpPr>
        <p:spPr>
          <a:xfrm>
            <a:off x="4689412" y="5962569"/>
            <a:ext cx="750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+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cxnSp>
        <p:nvCxnSpPr>
          <p:cNvPr id="116" name="直線コネクタ 115">
            <a:extLst>
              <a:ext uri="{FF2B5EF4-FFF2-40B4-BE49-F238E27FC236}">
                <a16:creationId xmlns:a16="http://schemas.microsoft.com/office/drawing/2014/main" id="{39D253BC-D075-E49F-BCC2-EA6561969C2B}"/>
              </a:ext>
            </a:extLst>
          </p:cNvPr>
          <p:cNvCxnSpPr>
            <a:cxnSpLocks/>
          </p:cNvCxnSpPr>
          <p:nvPr/>
        </p:nvCxnSpPr>
        <p:spPr>
          <a:xfrm>
            <a:off x="751466" y="7508993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4703B642-E34F-4407-9219-5962A80727C4}"/>
              </a:ext>
            </a:extLst>
          </p:cNvPr>
          <p:cNvSpPr txBox="1"/>
          <p:nvPr/>
        </p:nvSpPr>
        <p:spPr>
          <a:xfrm>
            <a:off x="1" y="7342172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500bp</a:t>
            </a:r>
            <a:endParaRPr kumimoji="1" lang="ja-JP" altLang="en-US"/>
          </a:p>
        </p:txBody>
      </p: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89815363-C1E4-A80C-7FE9-15474D91CB04}"/>
              </a:ext>
            </a:extLst>
          </p:cNvPr>
          <p:cNvCxnSpPr>
            <a:cxnSpLocks/>
          </p:cNvCxnSpPr>
          <p:nvPr/>
        </p:nvCxnSpPr>
        <p:spPr>
          <a:xfrm>
            <a:off x="751466" y="8086522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EB024F15-813A-0695-7C48-44B9F5B98A0A}"/>
              </a:ext>
            </a:extLst>
          </p:cNvPr>
          <p:cNvSpPr txBox="1"/>
          <p:nvPr/>
        </p:nvSpPr>
        <p:spPr>
          <a:xfrm>
            <a:off x="0" y="7880327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100bp</a:t>
            </a:r>
            <a:endParaRPr kumimoji="1" lang="ja-JP" altLang="en-US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3A5A1783-9976-96A3-A98F-1D578ED7D1BA}"/>
              </a:ext>
            </a:extLst>
          </p:cNvPr>
          <p:cNvSpPr txBox="1"/>
          <p:nvPr/>
        </p:nvSpPr>
        <p:spPr>
          <a:xfrm>
            <a:off x="153420" y="263867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00F86C37-4BCB-0D1D-B740-D9F8AA67BD83}"/>
              </a:ext>
            </a:extLst>
          </p:cNvPr>
          <p:cNvSpPr txBox="1"/>
          <p:nvPr/>
        </p:nvSpPr>
        <p:spPr>
          <a:xfrm>
            <a:off x="153420" y="5052071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6103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4456A393-24A2-99C1-730B-9B0E4CFEAB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160" y="1121923"/>
            <a:ext cx="6254766" cy="367793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6B41D73-771B-28C2-8891-E9F0C5F16FE1}"/>
              </a:ext>
            </a:extLst>
          </p:cNvPr>
          <p:cNvSpPr txBox="1"/>
          <p:nvPr/>
        </p:nvSpPr>
        <p:spPr>
          <a:xfrm>
            <a:off x="4565515" y="1452663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8454.8</a:t>
            </a:r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FBAEC14-F958-7A5A-8C3D-6427D500843B}"/>
              </a:ext>
            </a:extLst>
          </p:cNvPr>
          <p:cNvSpPr txBox="1"/>
          <p:nvPr/>
        </p:nvSpPr>
        <p:spPr>
          <a:xfrm>
            <a:off x="222115" y="5389310"/>
            <a:ext cx="641377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.	MS results of the </a:t>
            </a:r>
            <a:r>
              <a:rPr lang="en-US" altLang="ja-JP" sz="1200" b="1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5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-labeled ChEC88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heoretical molecular weight of 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5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-ChEC88, in which all ten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ys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esidues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er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ir oxidized forms, was calculated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 b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8453.37. The observed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/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z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value, 8454.8, indicated that ChEC88 contained five SS bonds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9673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8FA9E8E-DC9B-52A7-1A11-06411B06BB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511" y="1682511"/>
            <a:ext cx="6414977" cy="502616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6105E53-5C86-5298-9D45-D3A8E16210CA}"/>
              </a:ext>
            </a:extLst>
          </p:cNvPr>
          <p:cNvSpPr txBox="1"/>
          <p:nvPr/>
        </p:nvSpPr>
        <p:spPr>
          <a:xfrm>
            <a:off x="291830" y="6961470"/>
            <a:ext cx="568743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3.</a:t>
            </a:r>
            <a:r>
              <a:rPr lang="en-US" altLang="ja-JP" sz="12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	</a:t>
            </a:r>
            <a:r>
              <a:rPr lang="en-US" altLang="ja-JP" sz="1200" b="1" kern="100" baseline="300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b="1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-</a:t>
            </a:r>
            <a:r>
              <a:rPr lang="en-US" altLang="ja-JP" sz="1200" b="1" kern="100" baseline="300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5</a:t>
            </a:r>
            <a:r>
              <a:rPr lang="en-US" altLang="ja-JP" sz="1200" b="1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 HSQC spectrum of ChEC88.</a:t>
            </a:r>
            <a:r>
              <a:rPr lang="en-US" altLang="ja-JP" sz="12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eaks are labeled with one-letter code amino acid type and residue number.</a:t>
            </a:r>
            <a:endParaRPr lang="ja-JP" altLang="ja-JP" sz="105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33361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A9AF53C6-B41C-B612-A140-DED410920DB4}"/>
              </a:ext>
            </a:extLst>
          </p:cNvPr>
          <p:cNvGrpSpPr/>
          <p:nvPr/>
        </p:nvGrpSpPr>
        <p:grpSpPr>
          <a:xfrm>
            <a:off x="200056" y="3456933"/>
            <a:ext cx="6088557" cy="2574951"/>
            <a:chOff x="200056" y="679091"/>
            <a:chExt cx="6088557" cy="2574951"/>
          </a:xfrm>
        </p:grpSpPr>
        <p:graphicFrame>
          <p:nvGraphicFramePr>
            <p:cNvPr id="3" name="图表 3">
              <a:extLst>
                <a:ext uri="{FF2B5EF4-FFF2-40B4-BE49-F238E27FC236}">
                  <a16:creationId xmlns:a16="http://schemas.microsoft.com/office/drawing/2014/main" id="{27D45895-5066-2B26-9C7B-D8E78568D33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5507373"/>
                </p:ext>
              </p:extLst>
            </p:nvPr>
          </p:nvGraphicFramePr>
          <p:xfrm>
            <a:off x="619333" y="679091"/>
            <a:ext cx="5669280" cy="25749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0BC08E9-5DC4-CDDC-F065-9954D568E8D8}"/>
                </a:ext>
              </a:extLst>
            </p:cNvPr>
            <p:cNvSpPr txBox="1"/>
            <p:nvPr/>
          </p:nvSpPr>
          <p:spPr>
            <a:xfrm rot="16200000">
              <a:off x="-24205" y="1768491"/>
              <a:ext cx="8178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/>
                <a:t>R</a:t>
              </a:r>
              <a:r>
                <a:rPr kumimoji="1" lang="en-US" altLang="ja-JP" baseline="-25000"/>
                <a:t>1</a:t>
              </a:r>
              <a:r>
                <a:rPr kumimoji="1" lang="ja-JP" altLang="en-US"/>
                <a:t> </a:t>
              </a:r>
              <a:r>
                <a:rPr kumimoji="1" lang="en-US" altLang="ja-JP"/>
                <a:t>(Hz)</a:t>
              </a:r>
              <a:endParaRPr kumimoji="1" lang="ja-JP" altLang="en-US"/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0FA32865-397A-8DE7-40CB-17D66E91DE78}"/>
              </a:ext>
            </a:extLst>
          </p:cNvPr>
          <p:cNvGrpSpPr/>
          <p:nvPr/>
        </p:nvGrpSpPr>
        <p:grpSpPr>
          <a:xfrm>
            <a:off x="1396716" y="756512"/>
            <a:ext cx="4095749" cy="154842"/>
            <a:chOff x="1514475" y="756512"/>
            <a:chExt cx="4095749" cy="154842"/>
          </a:xfrm>
        </p:grpSpPr>
        <p:sp>
          <p:nvSpPr>
            <p:cNvPr id="12" name="矢印: 右 11">
              <a:extLst>
                <a:ext uri="{FF2B5EF4-FFF2-40B4-BE49-F238E27FC236}">
                  <a16:creationId xmlns:a16="http://schemas.microsoft.com/office/drawing/2014/main" id="{086C8970-901D-D29C-C093-3CB4CAD77FF1}"/>
                </a:ext>
              </a:extLst>
            </p:cNvPr>
            <p:cNvSpPr/>
            <p:nvPr/>
          </p:nvSpPr>
          <p:spPr>
            <a:xfrm>
              <a:off x="2613024" y="756512"/>
              <a:ext cx="320675" cy="154842"/>
            </a:xfrm>
            <a:prstGeom prst="rightArrow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矢印: 右 12">
              <a:extLst>
                <a:ext uri="{FF2B5EF4-FFF2-40B4-BE49-F238E27FC236}">
                  <a16:creationId xmlns:a16="http://schemas.microsoft.com/office/drawing/2014/main" id="{7CDAD26F-54FE-D77C-3E86-C2436CFCDDF5}"/>
                </a:ext>
              </a:extLst>
            </p:cNvPr>
            <p:cNvSpPr/>
            <p:nvPr/>
          </p:nvSpPr>
          <p:spPr>
            <a:xfrm>
              <a:off x="3086099" y="756512"/>
              <a:ext cx="320675" cy="154842"/>
            </a:xfrm>
            <a:prstGeom prst="rightArrow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矢印: 右 13">
              <a:extLst>
                <a:ext uri="{FF2B5EF4-FFF2-40B4-BE49-F238E27FC236}">
                  <a16:creationId xmlns:a16="http://schemas.microsoft.com/office/drawing/2014/main" id="{77FC4A85-A8C8-237C-05E0-E2B9C960FD02}"/>
                </a:ext>
              </a:extLst>
            </p:cNvPr>
            <p:cNvSpPr/>
            <p:nvPr/>
          </p:nvSpPr>
          <p:spPr>
            <a:xfrm>
              <a:off x="4687356" y="756512"/>
              <a:ext cx="320675" cy="154842"/>
            </a:xfrm>
            <a:prstGeom prst="rightArrow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矢印: 右 14">
              <a:extLst>
                <a:ext uri="{FF2B5EF4-FFF2-40B4-BE49-F238E27FC236}">
                  <a16:creationId xmlns:a16="http://schemas.microsoft.com/office/drawing/2014/main" id="{120967BA-11C1-6960-5A4E-77DCEFD33D50}"/>
                </a:ext>
              </a:extLst>
            </p:cNvPr>
            <p:cNvSpPr/>
            <p:nvPr/>
          </p:nvSpPr>
          <p:spPr>
            <a:xfrm>
              <a:off x="5289549" y="756512"/>
              <a:ext cx="320675" cy="154842"/>
            </a:xfrm>
            <a:prstGeom prst="rightArrow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8D82CDB3-48A1-D2F8-9759-0711148475CB}"/>
                </a:ext>
              </a:extLst>
            </p:cNvPr>
            <p:cNvSpPr/>
            <p:nvPr/>
          </p:nvSpPr>
          <p:spPr>
            <a:xfrm>
              <a:off x="1514475" y="781704"/>
              <a:ext cx="479425" cy="104459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1A8BEBF2-E5E7-3DEE-DEF4-2E23B62DAB41}"/>
                </a:ext>
              </a:extLst>
            </p:cNvPr>
            <p:cNvSpPr/>
            <p:nvPr/>
          </p:nvSpPr>
          <p:spPr>
            <a:xfrm>
              <a:off x="3808410" y="781704"/>
              <a:ext cx="636590" cy="104459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CF0DAA0-B346-AA24-81FA-0B010DE9113F}"/>
              </a:ext>
            </a:extLst>
          </p:cNvPr>
          <p:cNvSpPr txBox="1"/>
          <p:nvPr/>
        </p:nvSpPr>
        <p:spPr>
          <a:xfrm>
            <a:off x="2665227" y="892685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residue number</a:t>
            </a:r>
            <a:endParaRPr kumimoji="1" lang="ja-JP" altLang="en-US"/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8EEAA7D6-FA46-D858-AE60-3676434A0D98}"/>
              </a:ext>
            </a:extLst>
          </p:cNvPr>
          <p:cNvGrpSpPr/>
          <p:nvPr/>
        </p:nvGrpSpPr>
        <p:grpSpPr>
          <a:xfrm>
            <a:off x="200055" y="6410916"/>
            <a:ext cx="6038611" cy="2574951"/>
            <a:chOff x="200055" y="3563801"/>
            <a:chExt cx="6038611" cy="2574951"/>
          </a:xfrm>
        </p:grpSpPr>
        <p:graphicFrame>
          <p:nvGraphicFramePr>
            <p:cNvPr id="5" name="グラフ 4">
              <a:extLst>
                <a:ext uri="{FF2B5EF4-FFF2-40B4-BE49-F238E27FC236}">
                  <a16:creationId xmlns:a16="http://schemas.microsoft.com/office/drawing/2014/main" id="{A5110D81-B0CD-D68F-8733-698AF659134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14724913"/>
                </p:ext>
              </p:extLst>
            </p:nvPr>
          </p:nvGraphicFramePr>
          <p:xfrm>
            <a:off x="619333" y="3563801"/>
            <a:ext cx="5619333" cy="25749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7FB26EF8-D9D7-D5F6-B96E-B24131F34908}"/>
                </a:ext>
              </a:extLst>
            </p:cNvPr>
            <p:cNvSpPr txBox="1"/>
            <p:nvPr/>
          </p:nvSpPr>
          <p:spPr>
            <a:xfrm rot="16200000">
              <a:off x="-24206" y="4876233"/>
              <a:ext cx="8178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/>
                <a:t>R</a:t>
              </a:r>
              <a:r>
                <a:rPr kumimoji="1" lang="en-US" altLang="ja-JP" i="1" baseline="-25000"/>
                <a:t>2</a:t>
              </a:r>
              <a:r>
                <a:rPr kumimoji="1" lang="ja-JP" altLang="en-US"/>
                <a:t> </a:t>
              </a:r>
              <a:r>
                <a:rPr kumimoji="1" lang="en-US" altLang="ja-JP"/>
                <a:t>(Hz)</a:t>
              </a:r>
              <a:endParaRPr kumimoji="1" lang="ja-JP" altLang="en-US"/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C9AC0083-13EE-27B1-5327-30CEC93D7489}"/>
                </a:ext>
              </a:extLst>
            </p:cNvPr>
            <p:cNvSpPr txBox="1"/>
            <p:nvPr/>
          </p:nvSpPr>
          <p:spPr>
            <a:xfrm>
              <a:off x="1323109" y="3883983"/>
              <a:ext cx="602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T15</a:t>
              </a:r>
              <a:endParaRPr kumimoji="1" lang="ja-JP" altLang="en-US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11F9EE46-5DDC-E2CF-995E-04BBCDCDB71E}"/>
                </a:ext>
              </a:extLst>
            </p:cNvPr>
            <p:cNvSpPr txBox="1"/>
            <p:nvPr/>
          </p:nvSpPr>
          <p:spPr>
            <a:xfrm>
              <a:off x="2823728" y="4056054"/>
              <a:ext cx="602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V37</a:t>
              </a:r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B503DAC4-FB30-9DC6-3764-5ECFCD3070E9}"/>
                </a:ext>
              </a:extLst>
            </p:cNvPr>
            <p:cNvSpPr txBox="1"/>
            <p:nvPr/>
          </p:nvSpPr>
          <p:spPr>
            <a:xfrm>
              <a:off x="3688719" y="4503915"/>
              <a:ext cx="602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C50</a:t>
              </a:r>
              <a:endParaRPr kumimoji="1" lang="ja-JP" altLang="en-US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17AE717-E0C2-AF6B-C66A-1060F68D804D}"/>
                </a:ext>
              </a:extLst>
            </p:cNvPr>
            <p:cNvSpPr txBox="1"/>
            <p:nvPr/>
          </p:nvSpPr>
          <p:spPr>
            <a:xfrm>
              <a:off x="3996063" y="4195387"/>
              <a:ext cx="602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Q53</a:t>
              </a:r>
              <a:endParaRPr kumimoji="1" lang="ja-JP" altLang="en-US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AEFCB963-6275-4469-63AD-133701C533F1}"/>
                </a:ext>
              </a:extLst>
            </p:cNvPr>
            <p:cNvSpPr txBox="1"/>
            <p:nvPr/>
          </p:nvSpPr>
          <p:spPr>
            <a:xfrm>
              <a:off x="3945031" y="3855842"/>
              <a:ext cx="602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H55</a:t>
              </a:r>
              <a:endParaRPr kumimoji="1" lang="ja-JP" altLang="en-US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0483CFC7-119E-9EAA-CA01-199A58F8BC79}"/>
                </a:ext>
              </a:extLst>
            </p:cNvPr>
            <p:cNvSpPr txBox="1"/>
            <p:nvPr/>
          </p:nvSpPr>
          <p:spPr>
            <a:xfrm>
              <a:off x="5589588" y="4056054"/>
              <a:ext cx="602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F76</a:t>
              </a:r>
              <a:endParaRPr kumimoji="1" lang="ja-JP" altLang="en-US"/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44B32787-C07C-5D89-CE92-6580BC551AA1}"/>
              </a:ext>
            </a:extLst>
          </p:cNvPr>
          <p:cNvGrpSpPr/>
          <p:nvPr/>
        </p:nvGrpSpPr>
        <p:grpSpPr>
          <a:xfrm>
            <a:off x="123837" y="1116622"/>
            <a:ext cx="6088558" cy="2226868"/>
            <a:chOff x="200055" y="6665367"/>
            <a:chExt cx="6088558" cy="2226868"/>
          </a:xfrm>
        </p:grpSpPr>
        <p:graphicFrame>
          <p:nvGraphicFramePr>
            <p:cNvPr id="8" name="グラフ 7">
              <a:extLst>
                <a:ext uri="{FF2B5EF4-FFF2-40B4-BE49-F238E27FC236}">
                  <a16:creationId xmlns:a16="http://schemas.microsoft.com/office/drawing/2014/main" id="{816FAE5B-6DF4-5E3C-C890-0085334A793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9645099"/>
                </p:ext>
              </p:extLst>
            </p:nvPr>
          </p:nvGraphicFramePr>
          <p:xfrm>
            <a:off x="619333" y="6665367"/>
            <a:ext cx="5669280" cy="22268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F130D8E7-3EE0-0326-B92E-934F8F4B696B}"/>
                </a:ext>
              </a:extLst>
            </p:cNvPr>
            <p:cNvSpPr txBox="1"/>
            <p:nvPr/>
          </p:nvSpPr>
          <p:spPr>
            <a:xfrm rot="16200000">
              <a:off x="-373564" y="7418820"/>
              <a:ext cx="15165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err="1"/>
                <a:t>NOE</a:t>
              </a:r>
              <a:r>
                <a:rPr kumimoji="1" lang="en-US" altLang="ja-JP" baseline="-25000" err="1"/>
                <a:t>on</a:t>
              </a:r>
              <a:r>
                <a:rPr kumimoji="1" lang="en-US" altLang="ja-JP" baseline="-25000"/>
                <a:t> </a:t>
              </a:r>
              <a:r>
                <a:rPr kumimoji="1" lang="en-US" altLang="ja-JP"/>
                <a:t>/ </a:t>
              </a:r>
              <a:r>
                <a:rPr kumimoji="1" lang="en-US" altLang="ja-JP" err="1"/>
                <a:t>NOE</a:t>
              </a:r>
              <a:r>
                <a:rPr kumimoji="1" lang="en-US" altLang="ja-JP" baseline="-25000" err="1"/>
                <a:t>off</a:t>
              </a:r>
              <a:endParaRPr kumimoji="1" lang="ja-JP" altLang="en-US" baseline="-2500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65C1D16A-1745-6DBA-6044-26B646EB596F}"/>
                </a:ext>
              </a:extLst>
            </p:cNvPr>
            <p:cNvSpPr txBox="1"/>
            <p:nvPr/>
          </p:nvSpPr>
          <p:spPr>
            <a:xfrm>
              <a:off x="3066483" y="7836711"/>
              <a:ext cx="602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D39</a:t>
              </a:r>
              <a:endParaRPr kumimoji="1" lang="ja-JP" altLang="en-US"/>
            </a:p>
          </p:txBody>
        </p:sp>
      </p:grp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F4DB0E9-B640-B69C-242C-415E67FC136E}"/>
              </a:ext>
            </a:extLst>
          </p:cNvPr>
          <p:cNvSpPr txBox="1"/>
          <p:nvPr/>
        </p:nvSpPr>
        <p:spPr>
          <a:xfrm>
            <a:off x="217231" y="212247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561F66E-9CE2-A2D1-D3F5-E846BC98D921}"/>
              </a:ext>
            </a:extLst>
          </p:cNvPr>
          <p:cNvSpPr txBox="1"/>
          <p:nvPr/>
        </p:nvSpPr>
        <p:spPr>
          <a:xfrm>
            <a:off x="217231" y="3320709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EC3624A-9265-FA94-9E36-B60986B8F322}"/>
              </a:ext>
            </a:extLst>
          </p:cNvPr>
          <p:cNvSpPr txBox="1"/>
          <p:nvPr/>
        </p:nvSpPr>
        <p:spPr>
          <a:xfrm>
            <a:off x="212417" y="6325361"/>
            <a:ext cx="41229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8A831BF-D966-DDA8-7FA7-4E559CDCFCA5}"/>
              </a:ext>
            </a:extLst>
          </p:cNvPr>
          <p:cNvSpPr txBox="1"/>
          <p:nvPr/>
        </p:nvSpPr>
        <p:spPr>
          <a:xfrm>
            <a:off x="33414" y="9351376"/>
            <a:ext cx="678597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4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	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MR relaxation results of ChEC88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 (a) heteronuclear 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5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-{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} NOE, (b)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</a:t>
            </a:r>
            <a:r>
              <a:rPr lang="en-US" altLang="ja-JP" sz="1200" kern="10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= 1/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200" kern="10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, and (c)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</a:t>
            </a:r>
            <a:r>
              <a:rPr lang="en-US" altLang="ja-JP" sz="1200" kern="10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= 1/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200" kern="10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.</a:t>
            </a:r>
            <a:r>
              <a:rPr lang="ja-JP" altLang="en-US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ar</a:t>
            </a:r>
            <a:r>
              <a:rPr lang="ja-JP" altLang="en-US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</a:t>
            </a:r>
            <a:r>
              <a:rPr lang="ja-JP" altLang="en-US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rrow</a:t>
            </a:r>
            <a:r>
              <a:rPr lang="ja-JP" altLang="en-US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dicate</a:t>
            </a:r>
            <a:r>
              <a:rPr lang="ja-JP" altLang="en-US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elix</a:t>
            </a:r>
            <a:r>
              <a:rPr lang="ja-JP" altLang="en-US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</a:t>
            </a:r>
            <a:r>
              <a:rPr lang="ja-JP" altLang="en-US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trand, respectively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64064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FA892A08-33FB-B593-4DD6-31F2AEC5F905}"/>
              </a:ext>
            </a:extLst>
          </p:cNvPr>
          <p:cNvGrpSpPr/>
          <p:nvPr/>
        </p:nvGrpSpPr>
        <p:grpSpPr>
          <a:xfrm>
            <a:off x="110903" y="598792"/>
            <a:ext cx="6636194" cy="8251977"/>
            <a:chOff x="110903" y="877652"/>
            <a:chExt cx="6636194" cy="8251977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2EC182D5-7270-6AE8-9D0A-5477447FB3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0903" y="1062318"/>
              <a:ext cx="6636194" cy="7442947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B9385D33-A3EA-C3B2-6371-B3D50FBDDAE3}"/>
                </a:ext>
              </a:extLst>
            </p:cNvPr>
            <p:cNvSpPr txBox="1"/>
            <p:nvPr/>
          </p:nvSpPr>
          <p:spPr>
            <a:xfrm>
              <a:off x="219669" y="877652"/>
              <a:ext cx="20372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Temp (</a:t>
              </a:r>
              <a:r>
                <a:rPr kumimoji="1" lang="en-US" altLang="ja-JP" baseline="30000" err="1"/>
                <a:t>o</a:t>
              </a:r>
              <a:r>
                <a:rPr kumimoji="1" lang="en-US" altLang="ja-JP" err="1"/>
                <a:t>C</a:t>
              </a:r>
              <a:r>
                <a:rPr kumimoji="1" lang="en-US" altLang="ja-JP"/>
                <a:t>)</a:t>
              </a:r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393E087E-F387-32A8-1F06-4D2F3C4AAD92}"/>
                </a:ext>
              </a:extLst>
            </p:cNvPr>
            <p:cNvSpPr txBox="1"/>
            <p:nvPr/>
          </p:nvSpPr>
          <p:spPr>
            <a:xfrm>
              <a:off x="410135" y="8390965"/>
              <a:ext cx="43152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10</a:t>
              </a:r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8D95ACDF-E75D-6795-61EB-AF75DEFC7FB7}"/>
                </a:ext>
              </a:extLst>
            </p:cNvPr>
            <p:cNvSpPr txBox="1"/>
            <p:nvPr/>
          </p:nvSpPr>
          <p:spPr>
            <a:xfrm>
              <a:off x="2008094" y="8390965"/>
              <a:ext cx="30809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9</a:t>
              </a:r>
              <a:endParaRPr kumimoji="1" lang="ja-JP" altLang="en-US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BB528062-35B0-6ABD-1C54-5723B92BD8B9}"/>
                </a:ext>
              </a:extLst>
            </p:cNvPr>
            <p:cNvSpPr txBox="1"/>
            <p:nvPr/>
          </p:nvSpPr>
          <p:spPr>
            <a:xfrm>
              <a:off x="3727077" y="8390965"/>
              <a:ext cx="30809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8</a:t>
              </a:r>
              <a:endParaRPr kumimoji="1" lang="ja-JP" altLang="en-US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A4F932E3-C813-1E66-53B0-52DD463E88E5}"/>
                </a:ext>
              </a:extLst>
            </p:cNvPr>
            <p:cNvSpPr txBox="1"/>
            <p:nvPr/>
          </p:nvSpPr>
          <p:spPr>
            <a:xfrm>
              <a:off x="5354170" y="8390965"/>
              <a:ext cx="30809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7</a:t>
              </a:r>
              <a:endParaRPr kumimoji="1" lang="ja-JP" altLang="en-US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F5763749-E3CD-6C37-B40A-6069E61770B9}"/>
                </a:ext>
              </a:extLst>
            </p:cNvPr>
            <p:cNvSpPr txBox="1"/>
            <p:nvPr/>
          </p:nvSpPr>
          <p:spPr>
            <a:xfrm>
              <a:off x="2771527" y="8760297"/>
              <a:ext cx="11095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aseline="30000"/>
                <a:t>1</a:t>
              </a:r>
              <a:r>
                <a:rPr kumimoji="1" lang="en-US" altLang="ja-JP"/>
                <a:t>H (ppm)</a:t>
              </a:r>
              <a:endParaRPr kumimoji="1" lang="ja-JP" altLang="en-US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C8B56868-3A6F-D73C-7FE3-93AD8830FE1A}"/>
                </a:ext>
              </a:extLst>
            </p:cNvPr>
            <p:cNvSpPr txBox="1"/>
            <p:nvPr/>
          </p:nvSpPr>
          <p:spPr>
            <a:xfrm flipH="1">
              <a:off x="219669" y="7140388"/>
              <a:ext cx="838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27</a:t>
              </a:r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C2DECDA-4774-41B2-837D-CAB81113A831}"/>
                </a:ext>
              </a:extLst>
            </p:cNvPr>
            <p:cNvSpPr txBox="1"/>
            <p:nvPr/>
          </p:nvSpPr>
          <p:spPr>
            <a:xfrm flipH="1">
              <a:off x="219669" y="6295891"/>
              <a:ext cx="838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35</a:t>
              </a:r>
              <a:endParaRPr kumimoji="1" lang="ja-JP" altLang="en-US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56F7627-0F41-8831-40D3-88824E91C320}"/>
                </a:ext>
              </a:extLst>
            </p:cNvPr>
            <p:cNvSpPr txBox="1"/>
            <p:nvPr/>
          </p:nvSpPr>
          <p:spPr>
            <a:xfrm flipH="1">
              <a:off x="219669" y="4084743"/>
              <a:ext cx="838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60</a:t>
              </a:r>
              <a:endParaRPr kumimoji="1" lang="ja-JP" altLang="en-US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00D7DCD-1BB9-FB8F-E565-524F07763E89}"/>
                </a:ext>
              </a:extLst>
            </p:cNvPr>
            <p:cNvSpPr txBox="1"/>
            <p:nvPr/>
          </p:nvSpPr>
          <p:spPr>
            <a:xfrm flipH="1">
              <a:off x="219669" y="5113433"/>
              <a:ext cx="838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50</a:t>
              </a:r>
              <a:endParaRPr kumimoji="1" lang="ja-JP" altLang="en-US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621A235-1B82-35CB-C305-D72605738805}"/>
                </a:ext>
              </a:extLst>
            </p:cNvPr>
            <p:cNvSpPr txBox="1"/>
            <p:nvPr/>
          </p:nvSpPr>
          <p:spPr>
            <a:xfrm flipH="1">
              <a:off x="219669" y="3309773"/>
              <a:ext cx="838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70</a:t>
              </a:r>
              <a:endParaRPr kumimoji="1" lang="ja-JP" altLang="en-US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469CD91B-94CC-838A-E80E-E0BB16F0898E}"/>
                </a:ext>
              </a:extLst>
            </p:cNvPr>
            <p:cNvSpPr txBox="1"/>
            <p:nvPr/>
          </p:nvSpPr>
          <p:spPr>
            <a:xfrm flipH="1">
              <a:off x="219669" y="2421378"/>
              <a:ext cx="838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80</a:t>
              </a:r>
              <a:endParaRPr kumimoji="1" lang="ja-JP" altLang="en-US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18843067-88B7-195A-E293-67F81F05E7B8}"/>
                </a:ext>
              </a:extLst>
            </p:cNvPr>
            <p:cNvSpPr txBox="1"/>
            <p:nvPr/>
          </p:nvSpPr>
          <p:spPr>
            <a:xfrm flipH="1">
              <a:off x="219669" y="1862398"/>
              <a:ext cx="8382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/>
                <a:t>27*</a:t>
              </a:r>
              <a:endParaRPr kumimoji="1" lang="ja-JP" altLang="en-US"/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A20AE7C-F2E2-41C9-880F-9141B23E0B3E}"/>
              </a:ext>
            </a:extLst>
          </p:cNvPr>
          <p:cNvSpPr txBox="1"/>
          <p:nvPr/>
        </p:nvSpPr>
        <p:spPr>
          <a:xfrm>
            <a:off x="340468" y="9122542"/>
            <a:ext cx="61770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5.	</a:t>
            </a:r>
            <a:r>
              <a:rPr lang="en-US" altLang="ja-JP" sz="1200" b="1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-NMR spectra of ChEC88 at various temperatures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romatic and amide proton regions are expanded.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 the top, 27*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dicates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he NMR spectrum of the sample at 27</a:t>
            </a:r>
            <a:r>
              <a:rPr lang="ja-JP" altLang="en-US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°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 after heat treatment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92542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1883E9-5937-BF13-47EF-56316D45BC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2EC6E4A-6BDD-F062-397F-9528A58316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77182"/>
            <a:ext cx="6858000" cy="357581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B31C2736-1FCB-5A31-C4A9-78547180A8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4495" y="5680935"/>
            <a:ext cx="3994118" cy="2950742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6D0012C-F596-D179-27FF-57066692E0A9}"/>
              </a:ext>
            </a:extLst>
          </p:cNvPr>
          <p:cNvSpPr txBox="1"/>
          <p:nvPr/>
        </p:nvSpPr>
        <p:spPr>
          <a:xfrm>
            <a:off x="795460" y="823302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69592AB-9D7C-C781-7545-3902D38DCA1F}"/>
              </a:ext>
            </a:extLst>
          </p:cNvPr>
          <p:cNvSpPr txBox="1"/>
          <p:nvPr/>
        </p:nvSpPr>
        <p:spPr>
          <a:xfrm>
            <a:off x="795460" y="5449276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1F27F01-8FC3-D713-F98D-64FA73E7109A}"/>
              </a:ext>
            </a:extLst>
          </p:cNvPr>
          <p:cNvSpPr txBox="1"/>
          <p:nvPr/>
        </p:nvSpPr>
        <p:spPr>
          <a:xfrm>
            <a:off x="138079" y="9128779"/>
            <a:ext cx="640411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6. Three-dimensional structures of BAS3 and ChEC88.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a) Modeled structure of BAS3,  (b) NMR structure of ChEC88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60775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E2437D4-C476-A1AA-B7AC-15ED3258B0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454" y="2876006"/>
            <a:ext cx="5817092" cy="252357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225E245-8AD5-1E22-685B-38BFCBBD60E9}"/>
              </a:ext>
            </a:extLst>
          </p:cNvPr>
          <p:cNvSpPr txBox="1"/>
          <p:nvPr/>
        </p:nvSpPr>
        <p:spPr>
          <a:xfrm>
            <a:off x="386932" y="6132028"/>
            <a:ext cx="615992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7. Alignment of the amino acid sequences of ChEC88 homologous proteins 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btained via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SI-Blast analysis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0020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FBAEC14-F958-7A5A-8C3D-6427D500843B}"/>
              </a:ext>
            </a:extLst>
          </p:cNvPr>
          <p:cNvSpPr txBox="1"/>
          <p:nvPr/>
        </p:nvSpPr>
        <p:spPr>
          <a:xfrm>
            <a:off x="222115" y="8893429"/>
            <a:ext cx="641377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8.</a:t>
            </a:r>
            <a:r>
              <a: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analysis by RT-PCR in </a:t>
            </a:r>
            <a:r>
              <a:rPr lang="en-US" altLang="ja-JP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Nicotiana </a:t>
            </a:r>
            <a:r>
              <a:rPr lang="en-US" altLang="ja-JP" sz="1200" b="1" i="1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leaves agroinfiltrated with ChEC88, CAD1, Cn88, and Fo88 constructs.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(a) Transcriptional expression of ChEC88, CAD1, Cn88, and Fo88. (b) Transcriptional expression of ChNLP1. “–RT” and “+RT” denote reactions performed in the absence and presence of reverse transcriptase, respectively, to validate RNA-specific amplification.</a:t>
            </a:r>
            <a:endParaRPr lang="ja-JP" altLang="ja-JP" sz="12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3EFC893-85F7-EDEF-3459-5DD2E38F9DB9}"/>
              </a:ext>
            </a:extLst>
          </p:cNvPr>
          <p:cNvSpPr txBox="1"/>
          <p:nvPr/>
        </p:nvSpPr>
        <p:spPr>
          <a:xfrm>
            <a:off x="665350" y="60145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FB802973-76FC-6919-A192-638135777870}"/>
              </a:ext>
            </a:extLst>
          </p:cNvPr>
          <p:cNvCxnSpPr>
            <a:cxnSpLocks/>
          </p:cNvCxnSpPr>
          <p:nvPr/>
        </p:nvCxnSpPr>
        <p:spPr>
          <a:xfrm>
            <a:off x="1212191" y="3060553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7556051-FB69-B17F-D856-7016C6E68D5C}"/>
              </a:ext>
            </a:extLst>
          </p:cNvPr>
          <p:cNvSpPr txBox="1"/>
          <p:nvPr/>
        </p:nvSpPr>
        <p:spPr>
          <a:xfrm>
            <a:off x="460726" y="2893732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500bp</a:t>
            </a:r>
            <a:endParaRPr kumimoji="1" lang="ja-JP" altLang="en-US"/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809DD59-5350-774D-15B3-9A2E50E07376}"/>
              </a:ext>
            </a:extLst>
          </p:cNvPr>
          <p:cNvCxnSpPr>
            <a:cxnSpLocks/>
          </p:cNvCxnSpPr>
          <p:nvPr/>
        </p:nvCxnSpPr>
        <p:spPr>
          <a:xfrm>
            <a:off x="1212191" y="3638082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20996C5-9E31-3007-64EB-B6F4C43EC297}"/>
              </a:ext>
            </a:extLst>
          </p:cNvPr>
          <p:cNvSpPr txBox="1"/>
          <p:nvPr/>
        </p:nvSpPr>
        <p:spPr>
          <a:xfrm>
            <a:off x="460725" y="3431887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100bp</a:t>
            </a:r>
            <a:endParaRPr kumimoji="1" lang="ja-JP" altLang="en-US"/>
          </a:p>
        </p:txBody>
      </p:sp>
      <p:pic>
        <p:nvPicPr>
          <p:cNvPr id="4" name="図 3" descr="写真, モニター, 座る, 開く が含まれている画像&#10;&#10;自動的に生成された説明">
            <a:extLst>
              <a:ext uri="{FF2B5EF4-FFF2-40B4-BE49-F238E27FC236}">
                <a16:creationId xmlns:a16="http://schemas.microsoft.com/office/drawing/2014/main" id="{63917F10-4D6F-C3A6-A120-D58610EC887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98" t="5590" r="27628" b="32624"/>
          <a:stretch/>
        </p:blipFill>
        <p:spPr>
          <a:xfrm>
            <a:off x="1408491" y="278544"/>
            <a:ext cx="4041018" cy="3534890"/>
          </a:xfrm>
          <a:prstGeom prst="rect">
            <a:avLst/>
          </a:prstGeom>
        </p:spPr>
      </p:pic>
      <p:pic>
        <p:nvPicPr>
          <p:cNvPr id="8" name="図 7" descr="屋内, モニター, 座る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9E319A21-379B-59AC-9B23-1377A7003CB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5" t="14357" r="48687" b="32624"/>
          <a:stretch/>
        </p:blipFill>
        <p:spPr>
          <a:xfrm>
            <a:off x="1408491" y="4848349"/>
            <a:ext cx="4041018" cy="3327746"/>
          </a:xfrm>
          <a:prstGeom prst="rect">
            <a:avLst/>
          </a:prstGeom>
        </p:spPr>
      </p:pic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4D33114-413E-A5AA-889D-D2589DA22816}"/>
              </a:ext>
            </a:extLst>
          </p:cNvPr>
          <p:cNvSpPr txBox="1"/>
          <p:nvPr/>
        </p:nvSpPr>
        <p:spPr>
          <a:xfrm rot="18909837">
            <a:off x="3369214" y="836230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977DB0A-4C6F-1732-68BA-BF425120E947}"/>
              </a:ext>
            </a:extLst>
          </p:cNvPr>
          <p:cNvSpPr txBox="1"/>
          <p:nvPr/>
        </p:nvSpPr>
        <p:spPr>
          <a:xfrm rot="18909837">
            <a:off x="3669206" y="8374827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AD1</a:t>
            </a:r>
            <a:endParaRPr kumimoji="1" lang="ja-JP" altLang="en-US" b="1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69CFC1B-CA8E-FB6F-7580-3E88CF1F4FF4}"/>
              </a:ext>
            </a:extLst>
          </p:cNvPr>
          <p:cNvSpPr txBox="1"/>
          <p:nvPr/>
        </p:nvSpPr>
        <p:spPr>
          <a:xfrm rot="18909837">
            <a:off x="3000331" y="836230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GFP</a:t>
            </a:r>
            <a:endParaRPr kumimoji="1" lang="ja-JP" altLang="en-US" b="1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A4A3D01F-6109-B12C-8605-A61FAAC598AE}"/>
              </a:ext>
            </a:extLst>
          </p:cNvPr>
          <p:cNvSpPr txBox="1"/>
          <p:nvPr/>
        </p:nvSpPr>
        <p:spPr>
          <a:xfrm rot="18909837">
            <a:off x="4011815" y="836230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n88</a:t>
            </a:r>
            <a:endParaRPr kumimoji="1" lang="ja-JP" altLang="en-US" b="1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2ACA06B-2B70-8FBB-42E6-8334EE62794F}"/>
              </a:ext>
            </a:extLst>
          </p:cNvPr>
          <p:cNvSpPr txBox="1"/>
          <p:nvPr/>
        </p:nvSpPr>
        <p:spPr>
          <a:xfrm rot="18909837">
            <a:off x="4324333" y="8374827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Fo88</a:t>
            </a:r>
            <a:endParaRPr kumimoji="1" lang="ja-JP" altLang="en-US" b="1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74AE73E-38DD-6DE8-9C31-676E65E66877}"/>
              </a:ext>
            </a:extLst>
          </p:cNvPr>
          <p:cNvSpPr txBox="1"/>
          <p:nvPr/>
        </p:nvSpPr>
        <p:spPr>
          <a:xfrm>
            <a:off x="2170177" y="1193684"/>
            <a:ext cx="638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-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FA08A327-9C64-86D9-1176-B1F735645922}"/>
              </a:ext>
            </a:extLst>
          </p:cNvPr>
          <p:cNvSpPr txBox="1"/>
          <p:nvPr/>
        </p:nvSpPr>
        <p:spPr>
          <a:xfrm>
            <a:off x="3927215" y="1193684"/>
            <a:ext cx="750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+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F5E277F-FC6C-4B1B-3393-F34ABBBEEBB5}"/>
              </a:ext>
            </a:extLst>
          </p:cNvPr>
          <p:cNvSpPr txBox="1"/>
          <p:nvPr/>
        </p:nvSpPr>
        <p:spPr>
          <a:xfrm>
            <a:off x="2170177" y="5918052"/>
            <a:ext cx="638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-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813D2BB-9D74-67BC-F81F-F68CA11A45B9}"/>
              </a:ext>
            </a:extLst>
          </p:cNvPr>
          <p:cNvSpPr txBox="1"/>
          <p:nvPr/>
        </p:nvSpPr>
        <p:spPr>
          <a:xfrm>
            <a:off x="4002371" y="5918052"/>
            <a:ext cx="750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solidFill>
                  <a:schemeClr val="bg1"/>
                </a:solidFill>
              </a:rPr>
              <a:t>(+RT)</a:t>
            </a:r>
            <a:endParaRPr kumimoji="1" lang="ja-JP" altLang="en-US" b="1">
              <a:solidFill>
                <a:schemeClr val="bg1"/>
              </a:solidFill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C6882C0-9037-0BBC-9DA8-EE634FA34B55}"/>
              </a:ext>
            </a:extLst>
          </p:cNvPr>
          <p:cNvSpPr txBox="1"/>
          <p:nvPr/>
        </p:nvSpPr>
        <p:spPr>
          <a:xfrm rot="18909837">
            <a:off x="1546345" y="836230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6968E34-B3A8-71B4-875C-B62FF3DC4F55}"/>
              </a:ext>
            </a:extLst>
          </p:cNvPr>
          <p:cNvSpPr txBox="1"/>
          <p:nvPr/>
        </p:nvSpPr>
        <p:spPr>
          <a:xfrm rot="18909837">
            <a:off x="1846337" y="8374827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AD1</a:t>
            </a:r>
            <a:endParaRPr kumimoji="1" lang="ja-JP" altLang="en-US" b="1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E1366FF-2121-A9A1-2213-A3D24D7E9EFC}"/>
              </a:ext>
            </a:extLst>
          </p:cNvPr>
          <p:cNvSpPr txBox="1"/>
          <p:nvPr/>
        </p:nvSpPr>
        <p:spPr>
          <a:xfrm rot="18909837">
            <a:off x="1177462" y="836230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GFP</a:t>
            </a:r>
            <a:endParaRPr kumimoji="1" lang="ja-JP" altLang="en-US" b="1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6A6EB85-D423-2F8B-9905-E8378FED8D52}"/>
              </a:ext>
            </a:extLst>
          </p:cNvPr>
          <p:cNvSpPr txBox="1"/>
          <p:nvPr/>
        </p:nvSpPr>
        <p:spPr>
          <a:xfrm rot="18909837">
            <a:off x="2188946" y="836230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n88</a:t>
            </a:r>
            <a:endParaRPr kumimoji="1" lang="ja-JP" altLang="en-US" b="1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C451F679-0E15-C291-3331-0A1B3134860C}"/>
              </a:ext>
            </a:extLst>
          </p:cNvPr>
          <p:cNvSpPr txBox="1"/>
          <p:nvPr/>
        </p:nvSpPr>
        <p:spPr>
          <a:xfrm rot="18909837">
            <a:off x="2501464" y="8374827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Fo88</a:t>
            </a:r>
            <a:endParaRPr kumimoji="1" lang="ja-JP" altLang="en-US" b="1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568D6B8-AEA6-3542-AE91-2A003CF5D56A}"/>
              </a:ext>
            </a:extLst>
          </p:cNvPr>
          <p:cNvSpPr txBox="1"/>
          <p:nvPr/>
        </p:nvSpPr>
        <p:spPr>
          <a:xfrm rot="18909837">
            <a:off x="3020857" y="3979708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0B48102E-0FB1-6AAC-714A-1FBC8A2A9713}"/>
              </a:ext>
            </a:extLst>
          </p:cNvPr>
          <p:cNvSpPr txBox="1"/>
          <p:nvPr/>
        </p:nvSpPr>
        <p:spPr>
          <a:xfrm rot="18909837">
            <a:off x="3378535" y="3992233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AD1</a:t>
            </a:r>
            <a:endParaRPr kumimoji="1" lang="ja-JP" altLang="en-US" b="1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5AE8F99-CA1D-FE90-0753-60077A5CF095}"/>
              </a:ext>
            </a:extLst>
          </p:cNvPr>
          <p:cNvSpPr txBox="1"/>
          <p:nvPr/>
        </p:nvSpPr>
        <p:spPr>
          <a:xfrm rot="18909837">
            <a:off x="3736213" y="3979708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n88</a:t>
            </a:r>
            <a:endParaRPr kumimoji="1" lang="ja-JP" altLang="en-US" b="1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316CE18-3CD4-B0EB-45EF-E560489DC570}"/>
              </a:ext>
            </a:extLst>
          </p:cNvPr>
          <p:cNvSpPr txBox="1"/>
          <p:nvPr/>
        </p:nvSpPr>
        <p:spPr>
          <a:xfrm rot="18909837">
            <a:off x="4093891" y="399223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Fo88</a:t>
            </a:r>
            <a:endParaRPr kumimoji="1" lang="ja-JP" altLang="en-US" b="1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7DF0C0EC-AF6D-8685-87FB-AA78ABFB4826}"/>
              </a:ext>
            </a:extLst>
          </p:cNvPr>
          <p:cNvSpPr txBox="1"/>
          <p:nvPr/>
        </p:nvSpPr>
        <p:spPr>
          <a:xfrm rot="18909837">
            <a:off x="1269940" y="3979708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hEC88</a:t>
            </a:r>
            <a:endParaRPr kumimoji="1" lang="ja-JP" altLang="en-US" b="1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02A70E62-13B7-8BFA-7D07-3B116C732711}"/>
              </a:ext>
            </a:extLst>
          </p:cNvPr>
          <p:cNvSpPr txBox="1"/>
          <p:nvPr/>
        </p:nvSpPr>
        <p:spPr>
          <a:xfrm rot="18909837">
            <a:off x="1627618" y="3992233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AD1</a:t>
            </a:r>
            <a:endParaRPr kumimoji="1" lang="ja-JP" altLang="en-US" b="1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64F7772D-4EE4-A36E-1484-D2CD416ED4D8}"/>
              </a:ext>
            </a:extLst>
          </p:cNvPr>
          <p:cNvSpPr txBox="1"/>
          <p:nvPr/>
        </p:nvSpPr>
        <p:spPr>
          <a:xfrm rot="18909837">
            <a:off x="1985296" y="3979708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Cn88</a:t>
            </a:r>
            <a:endParaRPr kumimoji="1" lang="ja-JP" altLang="en-US" b="1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C4BE809-55A2-98C6-4F73-3577AE9B2FE6}"/>
              </a:ext>
            </a:extLst>
          </p:cNvPr>
          <p:cNvSpPr txBox="1"/>
          <p:nvPr/>
        </p:nvSpPr>
        <p:spPr>
          <a:xfrm rot="18909837">
            <a:off x="2342974" y="3992232"/>
            <a:ext cx="970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b="1"/>
              <a:t>Fo88</a:t>
            </a:r>
            <a:endParaRPr kumimoji="1" lang="ja-JP" altLang="en-US" b="1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E4F008AA-98E0-6973-8036-2E2C0F4ADB90}"/>
              </a:ext>
            </a:extLst>
          </p:cNvPr>
          <p:cNvSpPr txBox="1"/>
          <p:nvPr/>
        </p:nvSpPr>
        <p:spPr>
          <a:xfrm>
            <a:off x="665350" y="4848349"/>
            <a:ext cx="44114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40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A1F84711-1E2C-6673-1664-5B87726699BE}"/>
              </a:ext>
            </a:extLst>
          </p:cNvPr>
          <p:cNvCxnSpPr>
            <a:cxnSpLocks/>
          </p:cNvCxnSpPr>
          <p:nvPr/>
        </p:nvCxnSpPr>
        <p:spPr>
          <a:xfrm>
            <a:off x="1212191" y="7488451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2E7DB60F-4A96-0115-D0FD-CBCB84D8EB04}"/>
              </a:ext>
            </a:extLst>
          </p:cNvPr>
          <p:cNvSpPr txBox="1"/>
          <p:nvPr/>
        </p:nvSpPr>
        <p:spPr>
          <a:xfrm>
            <a:off x="460726" y="7321630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500bp</a:t>
            </a:r>
            <a:endParaRPr kumimoji="1" lang="ja-JP" altLang="en-US"/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5A2590D0-A5AF-7749-3BE8-7B66074B7EB6}"/>
              </a:ext>
            </a:extLst>
          </p:cNvPr>
          <p:cNvCxnSpPr>
            <a:cxnSpLocks/>
          </p:cNvCxnSpPr>
          <p:nvPr/>
        </p:nvCxnSpPr>
        <p:spPr>
          <a:xfrm>
            <a:off x="1212191" y="8065980"/>
            <a:ext cx="196299" cy="32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2B214FB4-240C-3C18-3AF8-42D0EC8E41E1}"/>
              </a:ext>
            </a:extLst>
          </p:cNvPr>
          <p:cNvSpPr txBox="1"/>
          <p:nvPr/>
        </p:nvSpPr>
        <p:spPr>
          <a:xfrm>
            <a:off x="460725" y="7859785"/>
            <a:ext cx="850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100bp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32482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EB495E2-A847-61B8-5F08-ECA6383068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406" y="228385"/>
            <a:ext cx="1844159" cy="147888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8075469-D804-F29A-8382-758F97E020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17132" y="354716"/>
            <a:ext cx="1709736" cy="154150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C4F7FAC-E16F-AD9B-1A5C-C46574BC9BA6}"/>
              </a:ext>
            </a:extLst>
          </p:cNvPr>
          <p:cNvSpPr txBox="1"/>
          <p:nvPr/>
        </p:nvSpPr>
        <p:spPr>
          <a:xfrm>
            <a:off x="1129040" y="1896217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wild</a:t>
            </a:r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79B6C9C-E121-F749-EE1F-E5C423E84B41}"/>
              </a:ext>
            </a:extLst>
          </p:cNvPr>
          <p:cNvSpPr txBox="1"/>
          <p:nvPr/>
        </p:nvSpPr>
        <p:spPr>
          <a:xfrm>
            <a:off x="4235932" y="1896217"/>
            <a:ext cx="434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6A</a:t>
            </a:r>
            <a:endParaRPr kumimoji="1" lang="ja-JP" altLang="en-US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8C9D4CD6-9B44-097F-FFBA-DC297B72D1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0829" y="2276579"/>
            <a:ext cx="1709736" cy="163248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390BA0E-C266-1898-3627-298DB6564E07}"/>
              </a:ext>
            </a:extLst>
          </p:cNvPr>
          <p:cNvSpPr txBox="1"/>
          <p:nvPr/>
        </p:nvSpPr>
        <p:spPr>
          <a:xfrm>
            <a:off x="1185812" y="3909062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L2A</a:t>
            </a:r>
            <a:endParaRPr kumimoji="1" lang="ja-JP" altLang="en-US"/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1BF5DB18-82F2-9521-72CB-B237B3F304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17132" y="2223337"/>
            <a:ext cx="1771869" cy="1550129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0CC195-935B-A796-785C-05F628E41156}"/>
              </a:ext>
            </a:extLst>
          </p:cNvPr>
          <p:cNvSpPr txBox="1"/>
          <p:nvPr/>
        </p:nvSpPr>
        <p:spPr>
          <a:xfrm>
            <a:off x="4332741" y="3909062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V4A</a:t>
            </a:r>
            <a:endParaRPr kumimoji="1" lang="ja-JP" altLang="en-US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7E64CDC3-4614-B65D-1D88-C0C82646C4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2952" y="4211640"/>
            <a:ext cx="1922246" cy="1816652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3348376-83CE-3AAA-DEC4-2F0802C26C03}"/>
              </a:ext>
            </a:extLst>
          </p:cNvPr>
          <p:cNvSpPr txBox="1"/>
          <p:nvPr/>
        </p:nvSpPr>
        <p:spPr>
          <a:xfrm>
            <a:off x="1388007" y="603062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N6A</a:t>
            </a:r>
            <a:endParaRPr kumimoji="1" lang="ja-JP" altLang="en-US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E2FF7D72-809F-DEB0-F45A-70AFFA0644E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71539" y="4304354"/>
            <a:ext cx="1908569" cy="1713398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B4F372-B2B2-2D95-958C-905611A8CDD5}"/>
              </a:ext>
            </a:extLst>
          </p:cNvPr>
          <p:cNvSpPr txBox="1"/>
          <p:nvPr/>
        </p:nvSpPr>
        <p:spPr>
          <a:xfrm>
            <a:off x="4292115" y="6017752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Q53A</a:t>
            </a:r>
            <a:endParaRPr kumimoji="1" lang="ja-JP" altLang="en-US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CC134D1E-E970-022E-590E-9F48B08B285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0829" y="6364296"/>
            <a:ext cx="1862788" cy="1679784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D61041A-F23D-6391-2A7B-278344A8C507}"/>
              </a:ext>
            </a:extLst>
          </p:cNvPr>
          <p:cNvSpPr txBox="1"/>
          <p:nvPr/>
        </p:nvSpPr>
        <p:spPr>
          <a:xfrm>
            <a:off x="1252720" y="8044080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H55A</a:t>
            </a:r>
            <a:endParaRPr kumimoji="1" lang="ja-JP" altLang="en-US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A9BDA09E-70B1-6FEA-5BEA-FFE5691B48D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22095" y="6284520"/>
            <a:ext cx="1746777" cy="1564278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7191CF2-3A01-187E-61DB-CAA3DEAE323E}"/>
              </a:ext>
            </a:extLst>
          </p:cNvPr>
          <p:cNvSpPr txBox="1"/>
          <p:nvPr/>
        </p:nvSpPr>
        <p:spPr>
          <a:xfrm>
            <a:off x="4335489" y="8044080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D71A</a:t>
            </a:r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89B4C0E-6AD0-A668-3D0F-23206EA303EC}"/>
              </a:ext>
            </a:extLst>
          </p:cNvPr>
          <p:cNvSpPr txBox="1"/>
          <p:nvPr/>
        </p:nvSpPr>
        <p:spPr>
          <a:xfrm>
            <a:off x="251013" y="9031254"/>
            <a:ext cx="635597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9.     Modeled structures of the ChEC88 mutants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EC88 mutant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tructures of mutants were generated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sing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odeller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[33] and AlphaFold2 [32]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3001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030a380-9b8f-478c-93e6-3b286cd0704a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0C480AF60DC06849A08B58D73B17D8A9" ma:contentTypeVersion="5" ma:contentTypeDescription="新しいドキュメントを作成します。" ma:contentTypeScope="" ma:versionID="b666e7a99c71024ecbd8cab80e01c8ac">
  <xsd:schema xmlns:xsd="http://www.w3.org/2001/XMLSchema" xmlns:xs="http://www.w3.org/2001/XMLSchema" xmlns:p="http://schemas.microsoft.com/office/2006/metadata/properties" xmlns:ns3="4030a380-9b8f-478c-93e6-3b286cd0704a" targetNamespace="http://schemas.microsoft.com/office/2006/metadata/properties" ma:root="true" ma:fieldsID="9cacc8a782580818a2eb3e0bbadf47a5" ns3:_="">
    <xsd:import namespace="4030a380-9b8f-478c-93e6-3b286cd0704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030a380-9b8f-478c-93e6-3b286cd0704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2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5B70D55-8899-4274-8634-748B22853DA1}">
  <ds:schemaRefs>
    <ds:schemaRef ds:uri="4030a380-9b8f-478c-93e6-3b286cd0704a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442D65C3-6CE2-4BE3-A3FE-2E7B559D61E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3FD6767-CDEB-4119-9C4F-264A1296E51F}">
  <ds:schemaRefs>
    <ds:schemaRef ds:uri="4030a380-9b8f-478c-93e6-3b286cd0704a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07</TotalTime>
  <Words>606</Words>
  <Application>Microsoft Office PowerPoint</Application>
  <PresentationFormat>A4 210 x 297 mm</PresentationFormat>
  <Paragraphs>140</Paragraphs>
  <Slides>1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7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原 浩之</dc:creator>
  <cp:lastModifiedBy>Shinya Ohki</cp:lastModifiedBy>
  <cp:revision>12</cp:revision>
  <dcterms:created xsi:type="dcterms:W3CDTF">2025-03-17T03:07:09Z</dcterms:created>
  <dcterms:modified xsi:type="dcterms:W3CDTF">2025-07-08T08:21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C480AF60DC06849A08B58D73B17D8A9</vt:lpwstr>
  </property>
</Properties>
</file>